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03" r:id="rId2"/>
    <p:sldId id="301" r:id="rId3"/>
    <p:sldId id="300" r:id="rId4"/>
    <p:sldId id="298" r:id="rId5"/>
    <p:sldId id="305" r:id="rId6"/>
    <p:sldId id="306" r:id="rId7"/>
    <p:sldId id="294" r:id="rId8"/>
    <p:sldId id="304" r:id="rId9"/>
    <p:sldId id="296" r:id="rId10"/>
  </p:sldIdLst>
  <p:sldSz cx="6858000" cy="9906000" type="A4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B9BD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029" autoAdjust="0"/>
    <p:restoredTop sz="94660"/>
  </p:normalViewPr>
  <p:slideViewPr>
    <p:cSldViewPr snapToGrid="0">
      <p:cViewPr varScale="1">
        <p:scale>
          <a:sx n="56" d="100"/>
          <a:sy n="56" d="100"/>
        </p:scale>
        <p:origin x="238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image" Target="../media/image6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9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image" Target="../media/image12.emf"/><Relationship Id="rId1" Type="http://schemas.openxmlformats.org/officeDocument/2006/relationships/image" Target="../media/image11.emf"/><Relationship Id="rId5" Type="http://schemas.openxmlformats.org/officeDocument/2006/relationships/image" Target="../media/image15.emf"/><Relationship Id="rId4" Type="http://schemas.openxmlformats.org/officeDocument/2006/relationships/image" Target="../media/image14.emf"/></Relationships>
</file>

<file path=ppt/drawings/_rels/vmlDrawing4.vml.rels><?xml version="1.0" encoding="UTF-8" standalone="yes"?>
<Relationships xmlns="http://schemas.openxmlformats.org/package/2006/relationships"><Relationship Id="rId8" Type="http://schemas.openxmlformats.org/officeDocument/2006/relationships/image" Target="../media/image25.emf"/><Relationship Id="rId3" Type="http://schemas.openxmlformats.org/officeDocument/2006/relationships/image" Target="../media/image20.emf"/><Relationship Id="rId7" Type="http://schemas.openxmlformats.org/officeDocument/2006/relationships/image" Target="../media/image24.emf"/><Relationship Id="rId2" Type="http://schemas.openxmlformats.org/officeDocument/2006/relationships/image" Target="../media/image19.emf"/><Relationship Id="rId1" Type="http://schemas.openxmlformats.org/officeDocument/2006/relationships/image" Target="../media/image18.emf"/><Relationship Id="rId6" Type="http://schemas.openxmlformats.org/officeDocument/2006/relationships/image" Target="../media/image23.emf"/><Relationship Id="rId5" Type="http://schemas.openxmlformats.org/officeDocument/2006/relationships/image" Target="../media/image22.emf"/><Relationship Id="rId10" Type="http://schemas.openxmlformats.org/officeDocument/2006/relationships/image" Target="../media/image27.emf"/><Relationship Id="rId4" Type="http://schemas.openxmlformats.org/officeDocument/2006/relationships/image" Target="../media/image21.emf"/><Relationship Id="rId9" Type="http://schemas.openxmlformats.org/officeDocument/2006/relationships/image" Target="../media/image26.emf"/></Relationships>
</file>

<file path=ppt/drawings/_rels/vmlDrawing5.vml.rels><?xml version="1.0" encoding="UTF-8" standalone="yes"?>
<Relationships xmlns="http://schemas.openxmlformats.org/package/2006/relationships"><Relationship Id="rId3" Type="http://schemas.openxmlformats.org/officeDocument/2006/relationships/image" Target="../media/image30.emf"/><Relationship Id="rId2" Type="http://schemas.openxmlformats.org/officeDocument/2006/relationships/image" Target="../media/image29.emf"/><Relationship Id="rId1" Type="http://schemas.openxmlformats.org/officeDocument/2006/relationships/image" Target="../media/image28.emf"/><Relationship Id="rId5" Type="http://schemas.openxmlformats.org/officeDocument/2006/relationships/image" Target="../media/image32.emf"/><Relationship Id="rId4" Type="http://schemas.openxmlformats.org/officeDocument/2006/relationships/image" Target="../media/image3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8D684-B934-4E57-AC99-927CA400504B}" type="datetimeFigureOut">
              <a:rPr lang="en-AU" smtClean="0"/>
              <a:t>10/04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2B32D-B9A0-4136-9DE1-D088C28AD2E8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993833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8D684-B934-4E57-AC99-927CA400504B}" type="datetimeFigureOut">
              <a:rPr lang="en-AU" smtClean="0"/>
              <a:t>10/04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2B32D-B9A0-4136-9DE1-D088C28AD2E8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553182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8D684-B934-4E57-AC99-927CA400504B}" type="datetimeFigureOut">
              <a:rPr lang="en-AU" smtClean="0"/>
              <a:t>10/04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2B32D-B9A0-4136-9DE1-D088C28AD2E8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718534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8D684-B934-4E57-AC99-927CA400504B}" type="datetimeFigureOut">
              <a:rPr lang="en-AU" smtClean="0"/>
              <a:t>10/04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2B32D-B9A0-4136-9DE1-D088C28AD2E8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514047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8D684-B934-4E57-AC99-927CA400504B}" type="datetimeFigureOut">
              <a:rPr lang="en-AU" smtClean="0"/>
              <a:t>10/04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2B32D-B9A0-4136-9DE1-D088C28AD2E8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676793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8D684-B934-4E57-AC99-927CA400504B}" type="datetimeFigureOut">
              <a:rPr lang="en-AU" smtClean="0"/>
              <a:t>10/04/202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2B32D-B9A0-4136-9DE1-D088C28AD2E8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746070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8D684-B934-4E57-AC99-927CA400504B}" type="datetimeFigureOut">
              <a:rPr lang="en-AU" smtClean="0"/>
              <a:t>10/04/2022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2B32D-B9A0-4136-9DE1-D088C28AD2E8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885390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8D684-B934-4E57-AC99-927CA400504B}" type="datetimeFigureOut">
              <a:rPr lang="en-AU" smtClean="0"/>
              <a:t>10/04/2022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2B32D-B9A0-4136-9DE1-D088C28AD2E8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898561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8D684-B934-4E57-AC99-927CA400504B}" type="datetimeFigureOut">
              <a:rPr lang="en-AU" smtClean="0"/>
              <a:t>10/04/2022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2B32D-B9A0-4136-9DE1-D088C28AD2E8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879899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8D684-B934-4E57-AC99-927CA400504B}" type="datetimeFigureOut">
              <a:rPr lang="en-AU" smtClean="0"/>
              <a:t>10/04/202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2B32D-B9A0-4136-9DE1-D088C28AD2E8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682829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8D684-B934-4E57-AC99-927CA400504B}" type="datetimeFigureOut">
              <a:rPr lang="en-AU" smtClean="0"/>
              <a:t>10/04/202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2B32D-B9A0-4136-9DE1-D088C28AD2E8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192980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18D684-B934-4E57-AC99-927CA400504B}" type="datetimeFigureOut">
              <a:rPr lang="en-AU" smtClean="0"/>
              <a:t>10/04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42B32D-B9A0-4136-9DE1-D088C28AD2E8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114858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7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6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9.emf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emf"/><Relationship Id="rId13" Type="http://schemas.openxmlformats.org/officeDocument/2006/relationships/oleObject" Target="../embeddings/oleObject9.bin"/><Relationship Id="rId3" Type="http://schemas.openxmlformats.org/officeDocument/2006/relationships/oleObject" Target="../embeddings/oleObject5.bin"/><Relationship Id="rId7" Type="http://schemas.openxmlformats.org/officeDocument/2006/relationships/oleObject" Target="../embeddings/oleObject7.bin"/><Relationship Id="rId12" Type="http://schemas.openxmlformats.org/officeDocument/2006/relationships/image" Target="../media/image17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12.emf"/><Relationship Id="rId11" Type="http://schemas.openxmlformats.org/officeDocument/2006/relationships/image" Target="../media/image16.png"/><Relationship Id="rId5" Type="http://schemas.openxmlformats.org/officeDocument/2006/relationships/oleObject" Target="../embeddings/oleObject6.bin"/><Relationship Id="rId10" Type="http://schemas.openxmlformats.org/officeDocument/2006/relationships/image" Target="../media/image14.emf"/><Relationship Id="rId4" Type="http://schemas.openxmlformats.org/officeDocument/2006/relationships/image" Target="../media/image11.emf"/><Relationship Id="rId9" Type="http://schemas.openxmlformats.org/officeDocument/2006/relationships/oleObject" Target="../embeddings/oleObject8.bin"/><Relationship Id="rId14" Type="http://schemas.openxmlformats.org/officeDocument/2006/relationships/image" Target="../media/image15.em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emf"/><Relationship Id="rId13" Type="http://schemas.openxmlformats.org/officeDocument/2006/relationships/oleObject" Target="../embeddings/oleObject15.bin"/><Relationship Id="rId18" Type="http://schemas.openxmlformats.org/officeDocument/2006/relationships/image" Target="../media/image25.emf"/><Relationship Id="rId3" Type="http://schemas.openxmlformats.org/officeDocument/2006/relationships/oleObject" Target="../embeddings/oleObject10.bin"/><Relationship Id="rId21" Type="http://schemas.openxmlformats.org/officeDocument/2006/relationships/oleObject" Target="../embeddings/oleObject19.bin"/><Relationship Id="rId7" Type="http://schemas.openxmlformats.org/officeDocument/2006/relationships/oleObject" Target="../embeddings/oleObject12.bin"/><Relationship Id="rId12" Type="http://schemas.openxmlformats.org/officeDocument/2006/relationships/image" Target="../media/image22.emf"/><Relationship Id="rId17" Type="http://schemas.openxmlformats.org/officeDocument/2006/relationships/oleObject" Target="../embeddings/oleObject17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24.emf"/><Relationship Id="rId20" Type="http://schemas.openxmlformats.org/officeDocument/2006/relationships/image" Target="../media/image26.emf"/><Relationship Id="rId1" Type="http://schemas.openxmlformats.org/officeDocument/2006/relationships/vmlDrawing" Target="../drawings/vmlDrawing4.vml"/><Relationship Id="rId6" Type="http://schemas.openxmlformats.org/officeDocument/2006/relationships/image" Target="../media/image19.emf"/><Relationship Id="rId11" Type="http://schemas.openxmlformats.org/officeDocument/2006/relationships/oleObject" Target="../embeddings/oleObject14.bin"/><Relationship Id="rId5" Type="http://schemas.openxmlformats.org/officeDocument/2006/relationships/oleObject" Target="../embeddings/oleObject11.bin"/><Relationship Id="rId15" Type="http://schemas.openxmlformats.org/officeDocument/2006/relationships/oleObject" Target="../embeddings/oleObject16.bin"/><Relationship Id="rId10" Type="http://schemas.openxmlformats.org/officeDocument/2006/relationships/image" Target="../media/image21.emf"/><Relationship Id="rId19" Type="http://schemas.openxmlformats.org/officeDocument/2006/relationships/oleObject" Target="../embeddings/oleObject18.bin"/><Relationship Id="rId4" Type="http://schemas.openxmlformats.org/officeDocument/2006/relationships/image" Target="../media/image18.emf"/><Relationship Id="rId9" Type="http://schemas.openxmlformats.org/officeDocument/2006/relationships/oleObject" Target="../embeddings/oleObject13.bin"/><Relationship Id="rId14" Type="http://schemas.openxmlformats.org/officeDocument/2006/relationships/image" Target="../media/image23.emf"/><Relationship Id="rId22" Type="http://schemas.openxmlformats.org/officeDocument/2006/relationships/image" Target="../media/image27.emf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emf"/><Relationship Id="rId13" Type="http://schemas.openxmlformats.org/officeDocument/2006/relationships/image" Target="../media/image33.emf"/><Relationship Id="rId3" Type="http://schemas.openxmlformats.org/officeDocument/2006/relationships/oleObject" Target="../embeddings/oleObject20.bin"/><Relationship Id="rId7" Type="http://schemas.openxmlformats.org/officeDocument/2006/relationships/oleObject" Target="../embeddings/oleObject22.bin"/><Relationship Id="rId12" Type="http://schemas.openxmlformats.org/officeDocument/2006/relationships/image" Target="../media/image32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.vml"/><Relationship Id="rId6" Type="http://schemas.openxmlformats.org/officeDocument/2006/relationships/image" Target="../media/image29.emf"/><Relationship Id="rId11" Type="http://schemas.openxmlformats.org/officeDocument/2006/relationships/oleObject" Target="../embeddings/oleObject24.bin"/><Relationship Id="rId5" Type="http://schemas.openxmlformats.org/officeDocument/2006/relationships/oleObject" Target="../embeddings/oleObject21.bin"/><Relationship Id="rId10" Type="http://schemas.openxmlformats.org/officeDocument/2006/relationships/image" Target="../media/image31.emf"/><Relationship Id="rId4" Type="http://schemas.openxmlformats.org/officeDocument/2006/relationships/image" Target="../media/image28.emf"/><Relationship Id="rId9" Type="http://schemas.openxmlformats.org/officeDocument/2006/relationships/oleObject" Target="../embeddings/oleObject23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e 1">
            <a:extLst>
              <a:ext uri="{FF2B5EF4-FFF2-40B4-BE49-F238E27FC236}">
                <a16:creationId xmlns:a16="http://schemas.microsoft.com/office/drawing/2014/main" xmlns="" id="{BA9C444E-0DA4-4E23-835C-F82019504052}"/>
              </a:ext>
            </a:extLst>
          </p:cNvPr>
          <p:cNvGraphicFramePr>
            <a:graphicFrameLocks noGrp="1"/>
          </p:cNvGraphicFramePr>
          <p:nvPr/>
        </p:nvGraphicFramePr>
        <p:xfrm>
          <a:off x="378891" y="1492320"/>
          <a:ext cx="5915025" cy="2578262"/>
        </p:xfrm>
        <a:graphic>
          <a:graphicData uri="http://schemas.openxmlformats.org/drawingml/2006/table">
            <a:tbl>
              <a:tblPr firstRow="1" firstCol="1" bandRow="1"/>
              <a:tblGrid>
                <a:gridCol w="509916">
                  <a:extLst>
                    <a:ext uri="{9D8B030D-6E8A-4147-A177-3AD203B41FA5}">
                      <a16:colId xmlns:a16="http://schemas.microsoft.com/office/drawing/2014/main" xmlns="" val="3050834029"/>
                    </a:ext>
                  </a:extLst>
                </a:gridCol>
                <a:gridCol w="620398">
                  <a:extLst>
                    <a:ext uri="{9D8B030D-6E8A-4147-A177-3AD203B41FA5}">
                      <a16:colId xmlns:a16="http://schemas.microsoft.com/office/drawing/2014/main" xmlns="" val="4133279421"/>
                    </a:ext>
                  </a:extLst>
                </a:gridCol>
                <a:gridCol w="1954678">
                  <a:extLst>
                    <a:ext uri="{9D8B030D-6E8A-4147-A177-3AD203B41FA5}">
                      <a16:colId xmlns:a16="http://schemas.microsoft.com/office/drawing/2014/main" xmlns="" val="1594626809"/>
                    </a:ext>
                  </a:extLst>
                </a:gridCol>
                <a:gridCol w="416431">
                  <a:extLst>
                    <a:ext uri="{9D8B030D-6E8A-4147-A177-3AD203B41FA5}">
                      <a16:colId xmlns:a16="http://schemas.microsoft.com/office/drawing/2014/main" xmlns="" val="273330286"/>
                    </a:ext>
                  </a:extLst>
                </a:gridCol>
                <a:gridCol w="1903686">
                  <a:extLst>
                    <a:ext uri="{9D8B030D-6E8A-4147-A177-3AD203B41FA5}">
                      <a16:colId xmlns:a16="http://schemas.microsoft.com/office/drawing/2014/main" xmlns="" val="920584165"/>
                    </a:ext>
                  </a:extLst>
                </a:gridCol>
                <a:gridCol w="509916">
                  <a:extLst>
                    <a:ext uri="{9D8B030D-6E8A-4147-A177-3AD203B41FA5}">
                      <a16:colId xmlns:a16="http://schemas.microsoft.com/office/drawing/2014/main" xmlns="" val="2365478067"/>
                    </a:ext>
                  </a:extLst>
                </a:gridCol>
              </a:tblGrid>
              <a:tr h="23477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 b="1" cap="all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enotype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 b="1" cap="all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Region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 b="1" cap="all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CR I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 b="1" cap="all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ize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 b="1" cap="all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CR II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 b="1" cap="all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ize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430886242"/>
                  </a:ext>
                </a:extLst>
              </a:tr>
              <a:tr h="25495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 b="1" cap="all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a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S3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CV1a-3c-F (TCCRAATGGAGACCAAGC)</a:t>
                      </a:r>
                      <a:b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</a:br>
                      <a: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CV1a-4c-R (AGCACAGCCYGCGTCATAGC)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649bp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CV1a-3d-F (GACAAAAACCAAGTGGAGGG)</a:t>
                      </a:r>
                      <a:b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</a:br>
                      <a: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CV1a-4b-R (AGCGTGRTTGTCTCAATGG)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280bp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301764157"/>
                  </a:ext>
                </a:extLst>
              </a:tr>
              <a:tr h="11473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 b="1" cap="all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de-DE" sz="7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de-DE" sz="7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de-DE" sz="7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de-DE" sz="7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de-DE" sz="7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634991882"/>
                  </a:ext>
                </a:extLst>
              </a:tr>
              <a:tr h="25495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 b="1" cap="all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b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E2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CV1b_2b-F (AACACCAAYGGCAGYTGG)</a:t>
                      </a:r>
                      <a:b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</a:br>
                      <a: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CV1b_2d-R (GGAGGATGATGGCATCGC)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384 bp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CV1b_2c-F (TGGTTYGGCTGTACATGG)</a:t>
                      </a:r>
                      <a:b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</a:br>
                      <a: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CV1b_2c-R (GCTATCAGCAGCATCATCC)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81bp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608817498"/>
                  </a:ext>
                </a:extLst>
              </a:tr>
              <a:tr h="25495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 b="1" cap="all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S3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CV1b-3274 (GACATGGAGACCAARRTCATCA)</a:t>
                      </a:r>
                      <a:b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</a:br>
                      <a: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CV1b-4d-R (CCAGGTGCTVGTGACGACC)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043bp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CV1b-3353 (CCGAAGGGGRARGGAGAT)</a:t>
                      </a:r>
                      <a:b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</a:br>
                      <a: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CV1b-4d-R (CCAGGTGCTVGTGACGACC)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689bp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564397254"/>
                  </a:ext>
                </a:extLst>
              </a:tr>
              <a:tr h="11473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 b="1" cap="all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7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7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7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7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7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223302257"/>
                  </a:ext>
                </a:extLst>
              </a:tr>
              <a:tr h="25495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 b="1" cap="all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b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S3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CV-2b-3152-F (GGCACTTACATCTATGACCAYCT)</a:t>
                      </a:r>
                      <a:b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</a:br>
                      <a: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CV-2b-5622-R (AAGTTCCACATRTGTTTGGCCCA)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470bp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CV-2b-3242-F (CCRATGGAGAAGAARGTCAT)</a:t>
                      </a:r>
                      <a:b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</a:br>
                      <a: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CV-2b-5445-R (TCCATCTCATCAAARGCCTC)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200bp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131540592"/>
                  </a:ext>
                </a:extLst>
              </a:tr>
              <a:tr h="11473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 b="1" cap="all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7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7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7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7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7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119584904"/>
                  </a:ext>
                </a:extLst>
              </a:tr>
              <a:tr h="35481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 b="1" cap="all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a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E2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CV3a-2367-F (CCTTGCTCYTTCACGCCCATG)</a:t>
                      </a:r>
                      <a:br>
                        <a:rPr lang="de-DE" sz="7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</a:br>
                      <a:r>
                        <a:rPr lang="de-DE" sz="7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CV3a-3276-R (CTAGCAGTGGCCACTGAACC)</a:t>
                      </a:r>
                      <a:endParaRPr lang="de-DE" sz="7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95bp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CV3a-2412-F (CACCTCCACCARAACATYGT)</a:t>
                      </a:r>
                      <a:b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</a:br>
                      <a: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CV3a-2847-R (TGGTGGAAYCAGTACRCCATATG)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82bp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960769572"/>
                  </a:ext>
                </a:extLst>
              </a:tr>
              <a:tr h="25495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 b="1" cap="all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S3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T3a-3256-F (CTAGCAGTGGCCACTGAACC)</a:t>
                      </a:r>
                      <a:b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</a:br>
                      <a: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T3a-5439-R (CACCTCYTTRTCTGGAACG)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180bp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T3a-3341-F (ATATTCTTTGCGGGCTGC)</a:t>
                      </a:r>
                      <a:b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</a:br>
                      <a: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T3a-4885-R (ACAACYGAGTCAAACATBCC)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544bp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442652399"/>
                  </a:ext>
                </a:extLst>
              </a:tr>
              <a:tr h="11473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 b="1" cap="all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de-DE" sz="7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de-DE" sz="7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de-DE" sz="7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de-DE" sz="7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de-DE" sz="7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544625496"/>
                  </a:ext>
                </a:extLst>
              </a:tr>
              <a:tr h="25495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 b="1" cap="all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S3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CV4-3264-F (RTRTTYACRSCYATGGAGAAG)</a:t>
                      </a:r>
                      <a:b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</a:br>
                      <a: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CV4-5621-R (YTGGGCRAARCACATGTGGAA)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357bp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CV-4-3364 (ATGAGATMYTGCTCGGRCCRGC)</a:t>
                      </a:r>
                      <a:b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</a:br>
                      <a:r>
                        <a:rPr lang="de-DE" sz="7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CV-4-5451 (CACTCYTCCATYTCRTCRAACTG)</a:t>
                      </a:r>
                      <a:endParaRPr lang="de-DE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7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087bp</a:t>
                      </a:r>
                      <a:endParaRPr lang="de-DE" sz="7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892" marR="458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245568038"/>
                  </a:ext>
                </a:extLst>
              </a:tr>
            </a:tbl>
          </a:graphicData>
        </a:graphic>
      </p:graphicFrame>
      <p:sp>
        <p:nvSpPr>
          <p:cNvPr id="3" name="Rectangle 1">
            <a:extLst>
              <a:ext uri="{FF2B5EF4-FFF2-40B4-BE49-F238E27FC236}">
                <a16:creationId xmlns:a16="http://schemas.microsoft.com/office/drawing/2014/main" xmlns="" id="{DCA7D75F-D9FA-4DB6-A2A9-18DB60A7B8A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6293" y="887623"/>
            <a:ext cx="5952461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de-DE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Table 1: </a:t>
            </a:r>
            <a:r>
              <a:rPr kumimoji="0" lang="en-US" altLang="de-D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enotype specific primers</a:t>
            </a:r>
            <a:endParaRPr kumimoji="0" lang="de-DE" altLang="de-DE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de-DE" altLang="de-DE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8980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1" name="Gruppieren 50"/>
          <p:cNvGrpSpPr/>
          <p:nvPr/>
        </p:nvGrpSpPr>
        <p:grpSpPr>
          <a:xfrm>
            <a:off x="165230" y="425781"/>
            <a:ext cx="6531658" cy="6991772"/>
            <a:chOff x="25894" y="-67685"/>
            <a:chExt cx="6531658" cy="6991772"/>
          </a:xfrm>
        </p:grpSpPr>
        <p:grpSp>
          <p:nvGrpSpPr>
            <p:cNvPr id="46" name="Gruppieren 45"/>
            <p:cNvGrpSpPr/>
            <p:nvPr/>
          </p:nvGrpSpPr>
          <p:grpSpPr>
            <a:xfrm>
              <a:off x="291602" y="254934"/>
              <a:ext cx="6170739" cy="4391709"/>
              <a:chOff x="20240" y="175493"/>
              <a:chExt cx="6170739" cy="4391709"/>
            </a:xfrm>
          </p:grpSpPr>
          <p:pic>
            <p:nvPicPr>
              <p:cNvPr id="2" name="Grafik 1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221501" y="175493"/>
                <a:ext cx="1800000" cy="1800000"/>
              </a:xfrm>
              <a:prstGeom prst="rect">
                <a:avLst/>
              </a:prstGeom>
            </p:spPr>
          </p:pic>
          <p:pic>
            <p:nvPicPr>
              <p:cNvPr id="3" name="Grafik 2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2306240" y="175493"/>
                <a:ext cx="1800000" cy="1800000"/>
              </a:xfrm>
              <a:prstGeom prst="rect">
                <a:avLst/>
              </a:prstGeom>
            </p:spPr>
          </p:pic>
          <p:pic>
            <p:nvPicPr>
              <p:cNvPr id="4" name="Grafik 3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4390979" y="175493"/>
                <a:ext cx="1800000" cy="1800000"/>
              </a:xfrm>
              <a:prstGeom prst="rect">
                <a:avLst/>
              </a:prstGeom>
            </p:spPr>
          </p:pic>
          <p:pic>
            <p:nvPicPr>
              <p:cNvPr id="5" name="Grafik 4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4390979" y="2447963"/>
                <a:ext cx="1800000" cy="1800000"/>
              </a:xfrm>
              <a:prstGeom prst="rect">
                <a:avLst/>
              </a:prstGeom>
            </p:spPr>
          </p:pic>
          <p:pic>
            <p:nvPicPr>
              <p:cNvPr id="6" name="Grafik 5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2306240" y="2447963"/>
                <a:ext cx="1800000" cy="1800000"/>
              </a:xfrm>
              <a:prstGeom prst="rect">
                <a:avLst/>
              </a:prstGeom>
            </p:spPr>
          </p:pic>
          <p:sp>
            <p:nvSpPr>
              <p:cNvPr id="10" name="Textfeld 9">
                <a:extLst>
                  <a:ext uri="{FF2B5EF4-FFF2-40B4-BE49-F238E27FC236}">
                    <a16:creationId xmlns:a16="http://schemas.microsoft.com/office/drawing/2014/main" xmlns="" id="{B570BCE5-C36B-4377-8E8B-ECF5DCC38980}"/>
                  </a:ext>
                </a:extLst>
              </p:cNvPr>
              <p:cNvSpPr txBox="1"/>
              <p:nvPr/>
            </p:nvSpPr>
            <p:spPr>
              <a:xfrm rot="16200000">
                <a:off x="-144549" y="1561277"/>
                <a:ext cx="57579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SC-A</a:t>
                </a:r>
              </a:p>
            </p:txBody>
          </p:sp>
          <p:cxnSp>
            <p:nvCxnSpPr>
              <p:cNvPr id="11" name="Gerade Verbindung mit Pfeil 10">
                <a:extLst>
                  <a:ext uri="{FF2B5EF4-FFF2-40B4-BE49-F238E27FC236}">
                    <a16:creationId xmlns:a16="http://schemas.microsoft.com/office/drawing/2014/main" xmlns="" id="{FF682C94-DE83-4546-9ED3-12BAB2D72845}"/>
                  </a:ext>
                </a:extLst>
              </p:cNvPr>
              <p:cNvCxnSpPr>
                <a:cxnSpLocks/>
                <a:stCxn id="10" idx="3"/>
              </p:cNvCxnSpPr>
              <p:nvPr/>
            </p:nvCxnSpPr>
            <p:spPr>
              <a:xfrm flipV="1">
                <a:off x="143351" y="175494"/>
                <a:ext cx="0" cy="122099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Gerade Verbindung mit Pfeil 11">
                <a:extLst>
                  <a:ext uri="{FF2B5EF4-FFF2-40B4-BE49-F238E27FC236}">
                    <a16:creationId xmlns:a16="http://schemas.microsoft.com/office/drawing/2014/main" xmlns="" id="{5F316F16-615C-43AA-8C8E-FE8B6BFFE1A8}"/>
                  </a:ext>
                </a:extLst>
              </p:cNvPr>
              <p:cNvCxnSpPr>
                <a:cxnSpLocks/>
                <a:stCxn id="13" idx="3"/>
              </p:cNvCxnSpPr>
              <p:nvPr/>
            </p:nvCxnSpPr>
            <p:spPr>
              <a:xfrm>
                <a:off x="835848" y="2164743"/>
                <a:ext cx="1185653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" name="Textfeld 12">
                <a:extLst>
                  <a:ext uri="{FF2B5EF4-FFF2-40B4-BE49-F238E27FC236}">
                    <a16:creationId xmlns:a16="http://schemas.microsoft.com/office/drawing/2014/main" xmlns="" id="{77954374-1F7E-492D-A69B-20020DEEB67A}"/>
                  </a:ext>
                </a:extLst>
              </p:cNvPr>
              <p:cNvSpPr txBox="1"/>
              <p:nvPr/>
            </p:nvSpPr>
            <p:spPr>
              <a:xfrm>
                <a:off x="266461" y="2041632"/>
                <a:ext cx="56938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FSC-A</a:t>
                </a:r>
              </a:p>
            </p:txBody>
          </p:sp>
          <p:sp>
            <p:nvSpPr>
              <p:cNvPr id="18" name="Textfeld 17">
                <a:extLst>
                  <a:ext uri="{FF2B5EF4-FFF2-40B4-BE49-F238E27FC236}">
                    <a16:creationId xmlns:a16="http://schemas.microsoft.com/office/drawing/2014/main" xmlns="" id="{B570BCE5-C36B-4377-8E8B-ECF5DCC38980}"/>
                  </a:ext>
                </a:extLst>
              </p:cNvPr>
              <p:cNvSpPr txBox="1"/>
              <p:nvPr/>
            </p:nvSpPr>
            <p:spPr>
              <a:xfrm rot="16200000">
                <a:off x="1939388" y="1607981"/>
                <a:ext cx="57740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FSC-H</a:t>
                </a:r>
              </a:p>
            </p:txBody>
          </p:sp>
          <p:cxnSp>
            <p:nvCxnSpPr>
              <p:cNvPr id="19" name="Gerade Verbindung mit Pfeil 18">
                <a:extLst>
                  <a:ext uri="{FF2B5EF4-FFF2-40B4-BE49-F238E27FC236}">
                    <a16:creationId xmlns:a16="http://schemas.microsoft.com/office/drawing/2014/main" xmlns="" id="{FF682C94-DE83-4546-9ED3-12BAB2D72845}"/>
                  </a:ext>
                </a:extLst>
              </p:cNvPr>
              <p:cNvCxnSpPr>
                <a:cxnSpLocks/>
                <a:stCxn id="18" idx="3"/>
              </p:cNvCxnSpPr>
              <p:nvPr/>
            </p:nvCxnSpPr>
            <p:spPr>
              <a:xfrm flipV="1">
                <a:off x="2228090" y="222206"/>
                <a:ext cx="0" cy="1220185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Gerade Verbindung mit Pfeil 19">
                <a:extLst>
                  <a:ext uri="{FF2B5EF4-FFF2-40B4-BE49-F238E27FC236}">
                    <a16:creationId xmlns:a16="http://schemas.microsoft.com/office/drawing/2014/main" xmlns="" id="{5F316F16-615C-43AA-8C8E-FE8B6BFFE1A8}"/>
                  </a:ext>
                </a:extLst>
              </p:cNvPr>
              <p:cNvCxnSpPr>
                <a:cxnSpLocks/>
                <a:stCxn id="21" idx="3"/>
              </p:cNvCxnSpPr>
              <p:nvPr/>
            </p:nvCxnSpPr>
            <p:spPr>
              <a:xfrm>
                <a:off x="2920587" y="2211447"/>
                <a:ext cx="1185653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" name="Textfeld 20">
                <a:extLst>
                  <a:ext uri="{FF2B5EF4-FFF2-40B4-BE49-F238E27FC236}">
                    <a16:creationId xmlns:a16="http://schemas.microsoft.com/office/drawing/2014/main" xmlns="" id="{77954374-1F7E-492D-A69B-20020DEEB67A}"/>
                  </a:ext>
                </a:extLst>
              </p:cNvPr>
              <p:cNvSpPr txBox="1"/>
              <p:nvPr/>
            </p:nvSpPr>
            <p:spPr>
              <a:xfrm>
                <a:off x="2351200" y="2088336"/>
                <a:ext cx="56938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FSC-A</a:t>
                </a:r>
              </a:p>
            </p:txBody>
          </p:sp>
          <p:sp>
            <p:nvSpPr>
              <p:cNvPr id="22" name="Textfeld 21">
                <a:extLst>
                  <a:ext uri="{FF2B5EF4-FFF2-40B4-BE49-F238E27FC236}">
                    <a16:creationId xmlns:a16="http://schemas.microsoft.com/office/drawing/2014/main" xmlns="" id="{B570BCE5-C36B-4377-8E8B-ECF5DCC38980}"/>
                  </a:ext>
                </a:extLst>
              </p:cNvPr>
              <p:cNvSpPr txBox="1"/>
              <p:nvPr/>
            </p:nvSpPr>
            <p:spPr>
              <a:xfrm rot="16200000">
                <a:off x="4022806" y="1561277"/>
                <a:ext cx="56938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FSC-A</a:t>
                </a:r>
              </a:p>
            </p:txBody>
          </p:sp>
          <p:cxnSp>
            <p:nvCxnSpPr>
              <p:cNvPr id="23" name="Gerade Verbindung mit Pfeil 22">
                <a:extLst>
                  <a:ext uri="{FF2B5EF4-FFF2-40B4-BE49-F238E27FC236}">
                    <a16:creationId xmlns:a16="http://schemas.microsoft.com/office/drawing/2014/main" xmlns="" id="{FF682C94-DE83-4546-9ED3-12BAB2D72845}"/>
                  </a:ext>
                </a:extLst>
              </p:cNvPr>
              <p:cNvCxnSpPr>
                <a:cxnSpLocks/>
                <a:stCxn id="22" idx="3"/>
              </p:cNvCxnSpPr>
              <p:nvPr/>
            </p:nvCxnSpPr>
            <p:spPr>
              <a:xfrm flipV="1">
                <a:off x="4307500" y="175502"/>
                <a:ext cx="0" cy="122419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Gerade Verbindung mit Pfeil 23">
                <a:extLst>
                  <a:ext uri="{FF2B5EF4-FFF2-40B4-BE49-F238E27FC236}">
                    <a16:creationId xmlns:a16="http://schemas.microsoft.com/office/drawing/2014/main" xmlns="" id="{5F316F16-615C-43AA-8C8E-FE8B6BFFE1A8}"/>
                  </a:ext>
                </a:extLst>
              </p:cNvPr>
              <p:cNvCxnSpPr>
                <a:cxnSpLocks/>
                <a:stCxn id="25" idx="3"/>
              </p:cNvCxnSpPr>
              <p:nvPr/>
            </p:nvCxnSpPr>
            <p:spPr>
              <a:xfrm>
                <a:off x="4814048" y="2164743"/>
                <a:ext cx="1371602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" name="Textfeld 24">
                <a:extLst>
                  <a:ext uri="{FF2B5EF4-FFF2-40B4-BE49-F238E27FC236}">
                    <a16:creationId xmlns:a16="http://schemas.microsoft.com/office/drawing/2014/main" xmlns="" id="{77954374-1F7E-492D-A69B-20020DEEB67A}"/>
                  </a:ext>
                </a:extLst>
              </p:cNvPr>
              <p:cNvSpPr txBox="1"/>
              <p:nvPr/>
            </p:nvSpPr>
            <p:spPr>
              <a:xfrm>
                <a:off x="4430610" y="2041632"/>
                <a:ext cx="3834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L/D</a:t>
                </a:r>
              </a:p>
            </p:txBody>
          </p:sp>
          <p:sp>
            <p:nvSpPr>
              <p:cNvPr id="26" name="Textfeld 25">
                <a:extLst>
                  <a:ext uri="{FF2B5EF4-FFF2-40B4-BE49-F238E27FC236}">
                    <a16:creationId xmlns:a16="http://schemas.microsoft.com/office/drawing/2014/main" xmlns="" id="{B570BCE5-C36B-4377-8E8B-ECF5DCC38980}"/>
                  </a:ext>
                </a:extLst>
              </p:cNvPr>
              <p:cNvSpPr txBox="1"/>
              <p:nvPr/>
            </p:nvSpPr>
            <p:spPr>
              <a:xfrm rot="16200000">
                <a:off x="4022806" y="3840626"/>
                <a:ext cx="56938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FSC-A</a:t>
                </a:r>
              </a:p>
            </p:txBody>
          </p:sp>
          <p:cxnSp>
            <p:nvCxnSpPr>
              <p:cNvPr id="27" name="Gerade Verbindung mit Pfeil 26">
                <a:extLst>
                  <a:ext uri="{FF2B5EF4-FFF2-40B4-BE49-F238E27FC236}">
                    <a16:creationId xmlns:a16="http://schemas.microsoft.com/office/drawing/2014/main" xmlns="" id="{FF682C94-DE83-4546-9ED3-12BAB2D72845}"/>
                  </a:ext>
                </a:extLst>
              </p:cNvPr>
              <p:cNvCxnSpPr>
                <a:cxnSpLocks/>
                <a:stCxn id="26" idx="3"/>
              </p:cNvCxnSpPr>
              <p:nvPr/>
            </p:nvCxnSpPr>
            <p:spPr>
              <a:xfrm flipV="1">
                <a:off x="4307500" y="2454851"/>
                <a:ext cx="0" cy="122419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Gerade Verbindung mit Pfeil 27">
                <a:extLst>
                  <a:ext uri="{FF2B5EF4-FFF2-40B4-BE49-F238E27FC236}">
                    <a16:creationId xmlns:a16="http://schemas.microsoft.com/office/drawing/2014/main" xmlns="" id="{5F316F16-615C-43AA-8C8E-FE8B6BFFE1A8}"/>
                  </a:ext>
                </a:extLst>
              </p:cNvPr>
              <p:cNvCxnSpPr>
                <a:cxnSpLocks/>
                <a:stCxn id="29" idx="3"/>
              </p:cNvCxnSpPr>
              <p:nvPr/>
            </p:nvCxnSpPr>
            <p:spPr>
              <a:xfrm>
                <a:off x="4871756" y="4444092"/>
                <a:ext cx="1313894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9" name="Textfeld 28">
                <a:extLst>
                  <a:ext uri="{FF2B5EF4-FFF2-40B4-BE49-F238E27FC236}">
                    <a16:creationId xmlns:a16="http://schemas.microsoft.com/office/drawing/2014/main" xmlns="" id="{77954374-1F7E-492D-A69B-20020DEEB67A}"/>
                  </a:ext>
                </a:extLst>
              </p:cNvPr>
              <p:cNvSpPr txBox="1"/>
              <p:nvPr/>
            </p:nvSpPr>
            <p:spPr>
              <a:xfrm>
                <a:off x="4430610" y="4320981"/>
                <a:ext cx="44114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D3</a:t>
                </a:r>
              </a:p>
            </p:txBody>
          </p:sp>
          <p:sp>
            <p:nvSpPr>
              <p:cNvPr id="30" name="Textfeld 29">
                <a:extLst>
                  <a:ext uri="{FF2B5EF4-FFF2-40B4-BE49-F238E27FC236}">
                    <a16:creationId xmlns:a16="http://schemas.microsoft.com/office/drawing/2014/main" xmlns="" id="{B570BCE5-C36B-4377-8E8B-ECF5DCC38980}"/>
                  </a:ext>
                </a:extLst>
              </p:cNvPr>
              <p:cNvSpPr txBox="1"/>
              <p:nvPr/>
            </p:nvSpPr>
            <p:spPr>
              <a:xfrm rot="16200000">
                <a:off x="2002187" y="3840626"/>
                <a:ext cx="44114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D8</a:t>
                </a:r>
              </a:p>
            </p:txBody>
          </p:sp>
          <p:cxnSp>
            <p:nvCxnSpPr>
              <p:cNvPr id="31" name="Gerade Verbindung mit Pfeil 30">
                <a:extLst>
                  <a:ext uri="{FF2B5EF4-FFF2-40B4-BE49-F238E27FC236}">
                    <a16:creationId xmlns:a16="http://schemas.microsoft.com/office/drawing/2014/main" xmlns="" id="{FF682C94-DE83-4546-9ED3-12BAB2D72845}"/>
                  </a:ext>
                </a:extLst>
              </p:cNvPr>
              <p:cNvCxnSpPr>
                <a:cxnSpLocks/>
                <a:stCxn id="30" idx="3"/>
              </p:cNvCxnSpPr>
              <p:nvPr/>
            </p:nvCxnSpPr>
            <p:spPr>
              <a:xfrm flipV="1">
                <a:off x="2222761" y="2454844"/>
                <a:ext cx="0" cy="128832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Gerade Verbindung mit Pfeil 31">
                <a:extLst>
                  <a:ext uri="{FF2B5EF4-FFF2-40B4-BE49-F238E27FC236}">
                    <a16:creationId xmlns:a16="http://schemas.microsoft.com/office/drawing/2014/main" xmlns="" id="{5F316F16-615C-43AA-8C8E-FE8B6BFFE1A8}"/>
                  </a:ext>
                </a:extLst>
              </p:cNvPr>
              <p:cNvCxnSpPr>
                <a:cxnSpLocks/>
                <a:stCxn id="33" idx="3"/>
              </p:cNvCxnSpPr>
              <p:nvPr/>
            </p:nvCxnSpPr>
            <p:spPr>
              <a:xfrm>
                <a:off x="3049910" y="4444092"/>
                <a:ext cx="1051001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" name="Textfeld 32">
                <a:extLst>
                  <a:ext uri="{FF2B5EF4-FFF2-40B4-BE49-F238E27FC236}">
                    <a16:creationId xmlns:a16="http://schemas.microsoft.com/office/drawing/2014/main" xmlns="" id="{77954374-1F7E-492D-A69B-20020DEEB67A}"/>
                  </a:ext>
                </a:extLst>
              </p:cNvPr>
              <p:cNvSpPr txBox="1"/>
              <p:nvPr/>
            </p:nvSpPr>
            <p:spPr>
              <a:xfrm>
                <a:off x="2345871" y="4320981"/>
                <a:ext cx="70403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etramer</a:t>
                </a:r>
              </a:p>
            </p:txBody>
          </p:sp>
          <p:cxnSp>
            <p:nvCxnSpPr>
              <p:cNvPr id="35" name="Gerade Verbindung mit Pfeil 34"/>
              <p:cNvCxnSpPr/>
              <p:nvPr/>
            </p:nvCxnSpPr>
            <p:spPr>
              <a:xfrm>
                <a:off x="1584996" y="1671583"/>
                <a:ext cx="1112894" cy="0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7" name="Gerade Verbindung mit Pfeil 36"/>
              <p:cNvCxnSpPr/>
              <p:nvPr/>
            </p:nvCxnSpPr>
            <p:spPr>
              <a:xfrm>
                <a:off x="3758862" y="703105"/>
                <a:ext cx="1112894" cy="0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8" name="Gerade Verbindung mit Pfeil 37"/>
              <p:cNvCxnSpPr/>
              <p:nvPr/>
            </p:nvCxnSpPr>
            <p:spPr>
              <a:xfrm>
                <a:off x="4814048" y="1671583"/>
                <a:ext cx="362636" cy="1012623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0" name="Gerade Verbindung mit Pfeil 39"/>
              <p:cNvCxnSpPr/>
              <p:nvPr/>
            </p:nvCxnSpPr>
            <p:spPr>
              <a:xfrm flipH="1">
                <a:off x="3930445" y="3663094"/>
                <a:ext cx="1360535" cy="0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44" name="Rechteck 43"/>
            <p:cNvSpPr/>
            <p:nvPr/>
          </p:nvSpPr>
          <p:spPr>
            <a:xfrm>
              <a:off x="45859" y="4892762"/>
              <a:ext cx="6511693" cy="203132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b="1" dirty="0"/>
                <a:t>Supplementary Figure 1: </a:t>
              </a:r>
              <a:r>
                <a:rPr lang="en-US" dirty="0"/>
                <a:t>(A) Lymphocytes were identified by forward scatter (FSC-A) and side scatter (SSC-A) gate. (B) Single cells were gated by a forward scatter height (FSC-H) and forward scatter area (FSC-A) gate. (C) Living cells were included only. (D) T cells were identified by CD3. (E) CD8+Tetramer+ were</a:t>
              </a:r>
            </a:p>
            <a:p>
              <a:r>
                <a:rPr lang="en-US" dirty="0"/>
                <a:t>selected to identify virus-specific T cells, CD8+ Tetramer- were selected to identify the bulk population.</a:t>
              </a:r>
              <a:endParaRPr lang="en-AU" dirty="0"/>
            </a:p>
          </p:txBody>
        </p:sp>
        <p:sp>
          <p:nvSpPr>
            <p:cNvPr id="45" name="Textfeld 44"/>
            <p:cNvSpPr txBox="1"/>
            <p:nvPr/>
          </p:nvSpPr>
          <p:spPr>
            <a:xfrm>
              <a:off x="4312504" y="-67685"/>
              <a:ext cx="3080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dirty="0"/>
                <a:t>C</a:t>
              </a:r>
            </a:p>
          </p:txBody>
        </p:sp>
        <p:sp>
          <p:nvSpPr>
            <p:cNvPr id="47" name="Textfeld 46"/>
            <p:cNvSpPr txBox="1"/>
            <p:nvPr/>
          </p:nvSpPr>
          <p:spPr>
            <a:xfrm>
              <a:off x="25894" y="-51087"/>
              <a:ext cx="3273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dirty="0"/>
                <a:t>A</a:t>
              </a:r>
            </a:p>
          </p:txBody>
        </p:sp>
        <p:sp>
          <p:nvSpPr>
            <p:cNvPr id="48" name="Rechteck 47"/>
            <p:cNvSpPr/>
            <p:nvPr/>
          </p:nvSpPr>
          <p:spPr>
            <a:xfrm>
              <a:off x="2207344" y="-52841"/>
              <a:ext cx="327334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AU" dirty="0"/>
                <a:t>B</a:t>
              </a:r>
            </a:p>
          </p:txBody>
        </p:sp>
        <p:sp>
          <p:nvSpPr>
            <p:cNvPr id="49" name="Textfeld 48"/>
            <p:cNvSpPr txBox="1"/>
            <p:nvPr/>
          </p:nvSpPr>
          <p:spPr>
            <a:xfrm>
              <a:off x="4309252" y="2244183"/>
              <a:ext cx="3273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dirty="0"/>
                <a:t>D</a:t>
              </a:r>
            </a:p>
          </p:txBody>
        </p:sp>
        <p:sp>
          <p:nvSpPr>
            <p:cNvPr id="50" name="Textfeld 49"/>
            <p:cNvSpPr txBox="1"/>
            <p:nvPr/>
          </p:nvSpPr>
          <p:spPr>
            <a:xfrm>
              <a:off x="2208629" y="2244183"/>
              <a:ext cx="3080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dirty="0"/>
                <a:t>E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7617451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e 1">
            <a:extLst>
              <a:ext uri="{FF2B5EF4-FFF2-40B4-BE49-F238E27FC236}">
                <a16:creationId xmlns:a16="http://schemas.microsoft.com/office/drawing/2014/main" xmlns="" id="{644B2AB7-5594-416A-A5A0-A22C4B31B76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84279371"/>
              </p:ext>
            </p:extLst>
          </p:nvPr>
        </p:nvGraphicFramePr>
        <p:xfrm>
          <a:off x="655040" y="686338"/>
          <a:ext cx="5571069" cy="7153744"/>
        </p:xfrm>
        <a:graphic>
          <a:graphicData uri="http://schemas.openxmlformats.org/drawingml/2006/table">
            <a:tbl>
              <a:tblPr>
                <a:tableStyleId>{8799B23B-EC83-4686-B30A-512413B5E67A}</a:tableStyleId>
              </a:tblPr>
              <a:tblGrid>
                <a:gridCol w="1725763">
                  <a:extLst>
                    <a:ext uri="{9D8B030D-6E8A-4147-A177-3AD203B41FA5}">
                      <a16:colId xmlns:a16="http://schemas.microsoft.com/office/drawing/2014/main" xmlns="" val="3365723571"/>
                    </a:ext>
                  </a:extLst>
                </a:gridCol>
                <a:gridCol w="1922653">
                  <a:extLst>
                    <a:ext uri="{9D8B030D-6E8A-4147-A177-3AD203B41FA5}">
                      <a16:colId xmlns:a16="http://schemas.microsoft.com/office/drawing/2014/main" xmlns="" val="2001950076"/>
                    </a:ext>
                  </a:extLst>
                </a:gridCol>
                <a:gridCol w="1922653">
                  <a:extLst>
                    <a:ext uri="{9D8B030D-6E8A-4147-A177-3AD203B41FA5}">
                      <a16:colId xmlns:a16="http://schemas.microsoft.com/office/drawing/2014/main" xmlns="" val="2746093548"/>
                    </a:ext>
                  </a:extLst>
                </a:gridCol>
              </a:tblGrid>
              <a:tr h="420784">
                <a:tc>
                  <a:txBody>
                    <a:bodyPr/>
                    <a:lstStyle/>
                    <a:p>
                      <a:pPr algn="l" fontAlgn="b"/>
                      <a:endParaRPr lang="de-DE" sz="2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>
                          <a:effectLst/>
                        </a:rPr>
                        <a:t>HCV-Panel</a:t>
                      </a:r>
                      <a:endParaRPr lang="de-DE" sz="2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>
                          <a:effectLst/>
                        </a:rPr>
                        <a:t>FLU-Panel</a:t>
                      </a:r>
                      <a:endParaRPr lang="de-DE" sz="2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extLst>
                  <a:ext uri="{0D108BD9-81ED-4DB2-BD59-A6C34878D82A}">
                    <a16:rowId xmlns:a16="http://schemas.microsoft.com/office/drawing/2014/main" xmlns="" val="1177901330"/>
                  </a:ext>
                </a:extLst>
              </a:tr>
              <a:tr h="420784"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>
                          <a:effectLst/>
                        </a:rPr>
                        <a:t>Fluorochome</a:t>
                      </a:r>
                      <a:endParaRPr lang="de-DE" sz="2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>
                          <a:effectLst/>
                        </a:rPr>
                        <a:t>Marker</a:t>
                      </a:r>
                      <a:endParaRPr lang="de-DE" sz="2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>
                          <a:effectLst/>
                        </a:rPr>
                        <a:t>Marker</a:t>
                      </a:r>
                      <a:endParaRPr lang="de-DE" sz="2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extLst>
                  <a:ext uri="{0D108BD9-81ED-4DB2-BD59-A6C34878D82A}">
                    <a16:rowId xmlns:a16="http://schemas.microsoft.com/office/drawing/2014/main" xmlns="" val="3257980752"/>
                  </a:ext>
                </a:extLst>
              </a:tr>
              <a:tr h="420784"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 dirty="0">
                          <a:effectLst/>
                        </a:rPr>
                        <a:t>BUV395</a:t>
                      </a:r>
                      <a:endParaRPr lang="de-DE" sz="2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>
                          <a:effectLst/>
                        </a:rPr>
                        <a:t>CD226</a:t>
                      </a:r>
                      <a:endParaRPr lang="de-DE" sz="2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>
                          <a:effectLst/>
                        </a:rPr>
                        <a:t>CD226</a:t>
                      </a:r>
                      <a:endParaRPr lang="de-DE" sz="2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extLst>
                  <a:ext uri="{0D108BD9-81ED-4DB2-BD59-A6C34878D82A}">
                    <a16:rowId xmlns:a16="http://schemas.microsoft.com/office/drawing/2014/main" xmlns="" val="3700531991"/>
                  </a:ext>
                </a:extLst>
              </a:tr>
              <a:tr h="420784"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>
                          <a:effectLst/>
                        </a:rPr>
                        <a:t>BUV737</a:t>
                      </a:r>
                      <a:endParaRPr lang="de-DE" sz="2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>
                          <a:effectLst/>
                        </a:rPr>
                        <a:t>CD39</a:t>
                      </a:r>
                      <a:endParaRPr lang="de-DE" sz="2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>
                          <a:effectLst/>
                        </a:rPr>
                        <a:t>CD39</a:t>
                      </a:r>
                      <a:endParaRPr lang="de-DE" sz="2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extLst>
                  <a:ext uri="{0D108BD9-81ED-4DB2-BD59-A6C34878D82A}">
                    <a16:rowId xmlns:a16="http://schemas.microsoft.com/office/drawing/2014/main" xmlns="" val="3821389029"/>
                  </a:ext>
                </a:extLst>
              </a:tr>
              <a:tr h="420784"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>
                          <a:effectLst/>
                        </a:rPr>
                        <a:t>BV421</a:t>
                      </a:r>
                      <a:endParaRPr lang="de-DE" sz="2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>
                          <a:effectLst/>
                        </a:rPr>
                        <a:t>TIGIT</a:t>
                      </a:r>
                      <a:endParaRPr lang="de-DE" sz="2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>
                          <a:effectLst/>
                        </a:rPr>
                        <a:t>TIGIT</a:t>
                      </a:r>
                      <a:endParaRPr lang="de-DE" sz="2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extLst>
                  <a:ext uri="{0D108BD9-81ED-4DB2-BD59-A6C34878D82A}">
                    <a16:rowId xmlns:a16="http://schemas.microsoft.com/office/drawing/2014/main" xmlns="" val="601002858"/>
                  </a:ext>
                </a:extLst>
              </a:tr>
              <a:tr h="420784"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>
                          <a:effectLst/>
                        </a:rPr>
                        <a:t>BV510</a:t>
                      </a:r>
                      <a:endParaRPr lang="de-DE" sz="2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>
                          <a:effectLst/>
                        </a:rPr>
                        <a:t>CD45RO</a:t>
                      </a:r>
                      <a:endParaRPr lang="de-DE" sz="2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>
                          <a:effectLst/>
                        </a:rPr>
                        <a:t>CD45RO</a:t>
                      </a:r>
                      <a:endParaRPr lang="de-DE" sz="2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extLst>
                  <a:ext uri="{0D108BD9-81ED-4DB2-BD59-A6C34878D82A}">
                    <a16:rowId xmlns:a16="http://schemas.microsoft.com/office/drawing/2014/main" xmlns="" val="237948236"/>
                  </a:ext>
                </a:extLst>
              </a:tr>
              <a:tr h="420784"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>
                          <a:effectLst/>
                        </a:rPr>
                        <a:t>BV605</a:t>
                      </a:r>
                      <a:endParaRPr lang="de-DE" sz="2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>
                          <a:effectLst/>
                        </a:rPr>
                        <a:t>CD73</a:t>
                      </a:r>
                      <a:endParaRPr lang="de-DE" sz="2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>
                          <a:effectLst/>
                        </a:rPr>
                        <a:t>CD73</a:t>
                      </a:r>
                      <a:endParaRPr lang="de-DE" sz="2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extLst>
                  <a:ext uri="{0D108BD9-81ED-4DB2-BD59-A6C34878D82A}">
                    <a16:rowId xmlns:a16="http://schemas.microsoft.com/office/drawing/2014/main" xmlns="" val="3107664341"/>
                  </a:ext>
                </a:extLst>
              </a:tr>
              <a:tr h="420784"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>
                          <a:effectLst/>
                        </a:rPr>
                        <a:t>BV711</a:t>
                      </a:r>
                      <a:endParaRPr lang="de-DE" sz="2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>
                          <a:effectLst/>
                        </a:rPr>
                        <a:t>T-bet</a:t>
                      </a:r>
                      <a:endParaRPr lang="de-DE" sz="2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>
                          <a:effectLst/>
                        </a:rPr>
                        <a:t>T-bet</a:t>
                      </a:r>
                      <a:endParaRPr lang="de-DE" sz="2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extLst>
                  <a:ext uri="{0D108BD9-81ED-4DB2-BD59-A6C34878D82A}">
                    <a16:rowId xmlns:a16="http://schemas.microsoft.com/office/drawing/2014/main" xmlns="" val="3609931231"/>
                  </a:ext>
                </a:extLst>
              </a:tr>
              <a:tr h="420784"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>
                          <a:effectLst/>
                        </a:rPr>
                        <a:t>BV785</a:t>
                      </a:r>
                      <a:endParaRPr lang="de-DE" sz="2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>
                          <a:effectLst/>
                        </a:rPr>
                        <a:t>CD127</a:t>
                      </a:r>
                      <a:endParaRPr lang="de-DE" sz="2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>
                          <a:effectLst/>
                        </a:rPr>
                        <a:t>CD127</a:t>
                      </a:r>
                      <a:endParaRPr lang="de-DE" sz="2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extLst>
                  <a:ext uri="{0D108BD9-81ED-4DB2-BD59-A6C34878D82A}">
                    <a16:rowId xmlns:a16="http://schemas.microsoft.com/office/drawing/2014/main" xmlns="" val="3478558036"/>
                  </a:ext>
                </a:extLst>
              </a:tr>
              <a:tr h="420784"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>
                          <a:effectLst/>
                        </a:rPr>
                        <a:t>FITC</a:t>
                      </a:r>
                      <a:endParaRPr lang="de-DE" sz="2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>
                          <a:effectLst/>
                        </a:rPr>
                        <a:t>KLRG1</a:t>
                      </a:r>
                      <a:endParaRPr lang="de-DE" sz="2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>
                          <a:effectLst/>
                        </a:rPr>
                        <a:t>KLRG1</a:t>
                      </a:r>
                      <a:endParaRPr lang="de-DE" sz="2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extLst>
                  <a:ext uri="{0D108BD9-81ED-4DB2-BD59-A6C34878D82A}">
                    <a16:rowId xmlns:a16="http://schemas.microsoft.com/office/drawing/2014/main" xmlns="" val="377357861"/>
                  </a:ext>
                </a:extLst>
              </a:tr>
              <a:tr h="420784"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>
                          <a:effectLst/>
                        </a:rPr>
                        <a:t>PerCP-Cy5.5</a:t>
                      </a:r>
                      <a:endParaRPr lang="de-DE" sz="2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>
                          <a:effectLst/>
                        </a:rPr>
                        <a:t>CD8</a:t>
                      </a:r>
                      <a:endParaRPr lang="de-DE" sz="2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>
                          <a:effectLst/>
                        </a:rPr>
                        <a:t>CD8</a:t>
                      </a:r>
                      <a:endParaRPr lang="de-DE" sz="2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extLst>
                  <a:ext uri="{0D108BD9-81ED-4DB2-BD59-A6C34878D82A}">
                    <a16:rowId xmlns:a16="http://schemas.microsoft.com/office/drawing/2014/main" xmlns="" val="3497240410"/>
                  </a:ext>
                </a:extLst>
              </a:tr>
              <a:tr h="420784"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>
                          <a:effectLst/>
                        </a:rPr>
                        <a:t>PE</a:t>
                      </a:r>
                      <a:endParaRPr lang="de-DE" sz="2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>
                          <a:effectLst/>
                        </a:rPr>
                        <a:t>Tetramer</a:t>
                      </a:r>
                      <a:endParaRPr lang="de-DE" sz="2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>
                          <a:effectLst/>
                        </a:rPr>
                        <a:t>TOX</a:t>
                      </a:r>
                      <a:endParaRPr lang="de-DE" sz="2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extLst>
                  <a:ext uri="{0D108BD9-81ED-4DB2-BD59-A6C34878D82A}">
                    <a16:rowId xmlns:a16="http://schemas.microsoft.com/office/drawing/2014/main" xmlns="" val="1709726752"/>
                  </a:ext>
                </a:extLst>
              </a:tr>
              <a:tr h="420784"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 dirty="0">
                          <a:effectLst/>
                        </a:rPr>
                        <a:t>PE-Cy7</a:t>
                      </a:r>
                      <a:endParaRPr lang="de-DE" sz="2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>
                          <a:effectLst/>
                        </a:rPr>
                        <a:t>PD-1</a:t>
                      </a:r>
                      <a:endParaRPr lang="de-DE" sz="2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>
                          <a:effectLst/>
                        </a:rPr>
                        <a:t>PD-1</a:t>
                      </a:r>
                      <a:endParaRPr lang="de-DE" sz="2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extLst>
                  <a:ext uri="{0D108BD9-81ED-4DB2-BD59-A6C34878D82A}">
                    <a16:rowId xmlns:a16="http://schemas.microsoft.com/office/drawing/2014/main" xmlns="" val="28712832"/>
                  </a:ext>
                </a:extLst>
              </a:tr>
              <a:tr h="421200"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 dirty="0">
                          <a:effectLst/>
                        </a:rPr>
                        <a:t>PE-eFluor610</a:t>
                      </a:r>
                      <a:endParaRPr lang="de-DE" sz="2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 dirty="0" err="1">
                          <a:effectLst/>
                        </a:rPr>
                        <a:t>Eomesodermin</a:t>
                      </a:r>
                      <a:endParaRPr lang="de-DE" sz="2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 dirty="0" err="1">
                          <a:effectLst/>
                        </a:rPr>
                        <a:t>Eomesodermin</a:t>
                      </a:r>
                      <a:endParaRPr lang="de-DE" sz="2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extLst>
                  <a:ext uri="{0D108BD9-81ED-4DB2-BD59-A6C34878D82A}">
                    <a16:rowId xmlns:a16="http://schemas.microsoft.com/office/drawing/2014/main" xmlns="" val="14056403"/>
                  </a:ext>
                </a:extLst>
              </a:tr>
              <a:tr h="420784"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>
                          <a:effectLst/>
                        </a:rPr>
                        <a:t>APC</a:t>
                      </a:r>
                      <a:endParaRPr lang="de-DE" sz="2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>
                          <a:effectLst/>
                        </a:rPr>
                        <a:t>TOX</a:t>
                      </a:r>
                      <a:endParaRPr lang="de-DE" sz="2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>
                          <a:effectLst/>
                        </a:rPr>
                        <a:t>Tetramer</a:t>
                      </a:r>
                      <a:endParaRPr lang="de-DE" sz="2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extLst>
                  <a:ext uri="{0D108BD9-81ED-4DB2-BD59-A6C34878D82A}">
                    <a16:rowId xmlns:a16="http://schemas.microsoft.com/office/drawing/2014/main" xmlns="" val="1697965059"/>
                  </a:ext>
                </a:extLst>
              </a:tr>
              <a:tr h="420784"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>
                          <a:effectLst/>
                        </a:rPr>
                        <a:t>AF700</a:t>
                      </a:r>
                      <a:endParaRPr lang="de-DE" sz="2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>
                          <a:effectLst/>
                        </a:rPr>
                        <a:t>CD3</a:t>
                      </a:r>
                      <a:endParaRPr lang="de-DE" sz="2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>
                          <a:effectLst/>
                        </a:rPr>
                        <a:t>CD3</a:t>
                      </a:r>
                      <a:endParaRPr lang="de-DE" sz="2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extLst>
                  <a:ext uri="{0D108BD9-81ED-4DB2-BD59-A6C34878D82A}">
                    <a16:rowId xmlns:a16="http://schemas.microsoft.com/office/drawing/2014/main" xmlns="" val="1708743392"/>
                  </a:ext>
                </a:extLst>
              </a:tr>
              <a:tr h="420784"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>
                          <a:effectLst/>
                        </a:rPr>
                        <a:t>APC-Cy7</a:t>
                      </a:r>
                      <a:endParaRPr lang="de-DE" sz="2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>
                          <a:effectLst/>
                        </a:rPr>
                        <a:t>Live/Dead</a:t>
                      </a:r>
                      <a:endParaRPr lang="de-DE" sz="2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2200" u="none" strike="noStrike" dirty="0">
                          <a:effectLst/>
                        </a:rPr>
                        <a:t>Live/Dead</a:t>
                      </a:r>
                      <a:endParaRPr lang="de-DE" sz="2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751" marR="18751" marT="18751" marB="0" anchor="b"/>
                </a:tc>
                <a:extLst>
                  <a:ext uri="{0D108BD9-81ED-4DB2-BD59-A6C34878D82A}">
                    <a16:rowId xmlns:a16="http://schemas.microsoft.com/office/drawing/2014/main" xmlns="" val="101860131"/>
                  </a:ext>
                </a:extLst>
              </a:tr>
            </a:tbl>
          </a:graphicData>
        </a:graphic>
      </p:graphicFrame>
      <p:sp>
        <p:nvSpPr>
          <p:cNvPr id="3" name="Rechteck 2"/>
          <p:cNvSpPr/>
          <p:nvPr/>
        </p:nvSpPr>
        <p:spPr>
          <a:xfrm>
            <a:off x="184327" y="8009841"/>
            <a:ext cx="657606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Supplementary Figure 2</a:t>
            </a:r>
            <a:r>
              <a:rPr lang="en-US" dirty="0"/>
              <a:t>: Overview of panels used for flow </a:t>
            </a:r>
            <a:r>
              <a:rPr lang="en-US" dirty="0" err="1"/>
              <a:t>cytometry</a:t>
            </a:r>
            <a:r>
              <a:rPr lang="en-US" dirty="0"/>
              <a:t>. </a:t>
            </a: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25961836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k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74856170"/>
              </p:ext>
            </p:extLst>
          </p:nvPr>
        </p:nvGraphicFramePr>
        <p:xfrm>
          <a:off x="201613" y="765175"/>
          <a:ext cx="2157412" cy="15160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701" name="Prism 7" r:id="rId3" imgW="3882983" imgH="2729247" progId="Prism7.Document">
                  <p:embed/>
                </p:oleObj>
              </mc:Choice>
              <mc:Fallback>
                <p:oleObj name="Prism 7" r:id="rId3" imgW="3882983" imgH="2729247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01613" y="765175"/>
                        <a:ext cx="2157412" cy="15160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k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2616005"/>
              </p:ext>
            </p:extLst>
          </p:nvPr>
        </p:nvGraphicFramePr>
        <p:xfrm>
          <a:off x="2360613" y="765175"/>
          <a:ext cx="2157412" cy="15160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702" name="Prism 7" r:id="rId5" imgW="3882983" imgH="2729247" progId="Prism7.Document">
                  <p:embed/>
                </p:oleObj>
              </mc:Choice>
              <mc:Fallback>
                <p:oleObj name="Prism 7" r:id="rId5" imgW="3882983" imgH="2729247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360613" y="765175"/>
                        <a:ext cx="2157412" cy="15160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k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59922679"/>
              </p:ext>
            </p:extLst>
          </p:nvPr>
        </p:nvGraphicFramePr>
        <p:xfrm>
          <a:off x="4520257" y="764780"/>
          <a:ext cx="2160000" cy="14846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703" name="Prism 7" r:id="rId7" imgW="3970136" imgH="2729247" progId="Prism7.Document">
                  <p:embed/>
                </p:oleObj>
              </mc:Choice>
              <mc:Fallback>
                <p:oleObj name="Prism 7" r:id="rId7" imgW="3970136" imgH="2729247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520257" y="764780"/>
                        <a:ext cx="2160000" cy="14846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feld 4"/>
          <p:cNvSpPr txBox="1"/>
          <p:nvPr/>
        </p:nvSpPr>
        <p:spPr>
          <a:xfrm>
            <a:off x="100128" y="2388610"/>
            <a:ext cx="668025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3</a:t>
            </a:r>
            <a:r>
              <a:rPr lang="en-US" dirty="0"/>
              <a:t>: Clinical laboratory parameters measured in HCV patients.</a:t>
            </a:r>
            <a:endParaRPr lang="en-AU" dirty="0"/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xmlns="" id="{C91D1DE0-548E-4DDE-810D-641710C903A2}"/>
              </a:ext>
            </a:extLst>
          </p:cNvPr>
          <p:cNvSpPr txBox="1"/>
          <p:nvPr/>
        </p:nvSpPr>
        <p:spPr>
          <a:xfrm>
            <a:off x="231493" y="52471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A</a:t>
            </a: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xmlns="" id="{18670CB2-3F22-47F7-9483-E7B408F77247}"/>
              </a:ext>
            </a:extLst>
          </p:cNvPr>
          <p:cNvSpPr txBox="1"/>
          <p:nvPr/>
        </p:nvSpPr>
        <p:spPr>
          <a:xfrm>
            <a:off x="2455761" y="52471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B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xmlns="" id="{CD958DF6-AF3C-4D14-93E9-CDFE7E8D4F12}"/>
              </a:ext>
            </a:extLst>
          </p:cNvPr>
          <p:cNvSpPr txBox="1"/>
          <p:nvPr/>
        </p:nvSpPr>
        <p:spPr>
          <a:xfrm>
            <a:off x="4633730" y="52471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73433180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>
            <a:extLst>
              <a:ext uri="{FF2B5EF4-FFF2-40B4-BE49-F238E27FC236}">
                <a16:creationId xmlns:a16="http://schemas.microsoft.com/office/drawing/2014/main" xmlns="" id="{28CD8C9B-49D7-4CDF-9B01-7D91392DCB2C}"/>
              </a:ext>
            </a:extLst>
          </p:cNvPr>
          <p:cNvGrpSpPr/>
          <p:nvPr/>
        </p:nvGrpSpPr>
        <p:grpSpPr>
          <a:xfrm>
            <a:off x="249972" y="396977"/>
            <a:ext cx="3122613" cy="2297112"/>
            <a:chOff x="-5196337" y="3561369"/>
            <a:chExt cx="3122613" cy="2297112"/>
          </a:xfrm>
        </p:grpSpPr>
        <p:graphicFrame>
          <p:nvGraphicFramePr>
            <p:cNvPr id="3" name="Objekt 2">
              <a:extLst>
                <a:ext uri="{FF2B5EF4-FFF2-40B4-BE49-F238E27FC236}">
                  <a16:creationId xmlns:a16="http://schemas.microsoft.com/office/drawing/2014/main" xmlns="" id="{21D721B7-C059-4FAD-AB43-283C351C51A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595793644"/>
                </p:ext>
              </p:extLst>
            </p:nvPr>
          </p:nvGraphicFramePr>
          <p:xfrm>
            <a:off x="-5196337" y="3561369"/>
            <a:ext cx="3122613" cy="22971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9705" name="Prism 7" r:id="rId3" imgW="3814557" imgH="2808481" progId="Prism7.Document">
                    <p:embed/>
                  </p:oleObj>
                </mc:Choice>
                <mc:Fallback>
                  <p:oleObj name="Prism 7" r:id="rId3" imgW="3814557" imgH="2808481" progId="Prism7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-5196337" y="3561369"/>
                          <a:ext cx="3122613" cy="22971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" name="Textfeld 3">
              <a:extLst>
                <a:ext uri="{FF2B5EF4-FFF2-40B4-BE49-F238E27FC236}">
                  <a16:creationId xmlns:a16="http://schemas.microsoft.com/office/drawing/2014/main" xmlns="" id="{DE24A5CD-D055-47C6-BC19-9E5875D89C94}"/>
                </a:ext>
              </a:extLst>
            </p:cNvPr>
            <p:cNvSpPr txBox="1"/>
            <p:nvPr/>
          </p:nvSpPr>
          <p:spPr>
            <a:xfrm>
              <a:off x="-3316520" y="4846822"/>
              <a:ext cx="85472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dirty="0">
                  <a:latin typeface="+mj-lt"/>
                </a:rPr>
                <a:t>r</a:t>
              </a:r>
              <a:r>
                <a:rPr lang="en-AU" sz="1400" baseline="30000" dirty="0">
                  <a:latin typeface="+mj-lt"/>
                </a:rPr>
                <a:t>2</a:t>
              </a:r>
              <a:r>
                <a:rPr lang="en-AU" sz="1400" dirty="0">
                  <a:latin typeface="+mj-lt"/>
                </a:rPr>
                <a:t>:0,5881</a:t>
              </a:r>
            </a:p>
            <a:p>
              <a:r>
                <a:rPr lang="en-AU" sz="1400" dirty="0">
                  <a:latin typeface="+mj-lt"/>
                </a:rPr>
                <a:t>p:0,0022</a:t>
              </a:r>
            </a:p>
          </p:txBody>
        </p:sp>
      </p:grpSp>
      <p:sp>
        <p:nvSpPr>
          <p:cNvPr id="6" name="Rechteck 5"/>
          <p:cNvSpPr/>
          <p:nvPr/>
        </p:nvSpPr>
        <p:spPr>
          <a:xfrm>
            <a:off x="249972" y="2694089"/>
            <a:ext cx="6381416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Supplementary Figure 4: </a:t>
            </a:r>
            <a:r>
              <a:rPr lang="en-US" dirty="0"/>
              <a:t>Correlation between Eomes+ and TOX+ </a:t>
            </a:r>
          </a:p>
          <a:p>
            <a:r>
              <a:rPr lang="en-US" dirty="0"/>
              <a:t>virus-specific CD8+ T cells. Blue dots represent the cHCV patients with on-target T cells, gray dots represent patients with unknown autologous viral sequence and red dots patients with off-target T cells corresponding to the analyzed viral sequence.</a:t>
            </a: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382184635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" y="-1"/>
            <a:ext cx="6858001" cy="5198038"/>
          </a:xfrm>
          <a:prstGeom prst="rect">
            <a:avLst/>
          </a:prstGeom>
        </p:spPr>
      </p:pic>
      <p:sp>
        <p:nvSpPr>
          <p:cNvPr id="3" name="Textfeld 2"/>
          <p:cNvSpPr txBox="1"/>
          <p:nvPr/>
        </p:nvSpPr>
        <p:spPr>
          <a:xfrm>
            <a:off x="88870" y="5198037"/>
            <a:ext cx="668025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5</a:t>
            </a:r>
            <a:r>
              <a:rPr lang="en-US" dirty="0"/>
              <a:t>: (A) </a:t>
            </a:r>
            <a:r>
              <a:rPr lang="en-US" dirty="0" err="1"/>
              <a:t>FlowSOM</a:t>
            </a:r>
            <a:r>
              <a:rPr lang="en-US" dirty="0"/>
              <a:t> cluster analysis of the different HCV disease stages. (B) </a:t>
            </a:r>
            <a:r>
              <a:rPr lang="en-US" dirty="0" err="1"/>
              <a:t>Heatmap</a:t>
            </a:r>
            <a:r>
              <a:rPr lang="en-US" dirty="0"/>
              <a:t> of MFI levels of used markers in </a:t>
            </a:r>
            <a:r>
              <a:rPr lang="en-US" dirty="0" err="1"/>
              <a:t>FlowSOM</a:t>
            </a:r>
            <a:r>
              <a:rPr lang="en-US" dirty="0"/>
              <a:t> cluster analysis.</a:t>
            </a:r>
            <a:endParaRPr lang="en-AU" dirty="0"/>
          </a:p>
        </p:txBody>
      </p:sp>
      <p:sp>
        <p:nvSpPr>
          <p:cNvPr id="4" name="Textfeld 3"/>
          <p:cNvSpPr txBox="1"/>
          <p:nvPr/>
        </p:nvSpPr>
        <p:spPr>
          <a:xfrm>
            <a:off x="88870" y="5565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A</a:t>
            </a:r>
          </a:p>
        </p:txBody>
      </p:sp>
      <p:sp>
        <p:nvSpPr>
          <p:cNvPr id="5" name="Textfeld 4"/>
          <p:cNvSpPr txBox="1"/>
          <p:nvPr/>
        </p:nvSpPr>
        <p:spPr>
          <a:xfrm>
            <a:off x="88870" y="219350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81258278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k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0953003"/>
              </p:ext>
            </p:extLst>
          </p:nvPr>
        </p:nvGraphicFramePr>
        <p:xfrm>
          <a:off x="1306849" y="806081"/>
          <a:ext cx="1108075" cy="1833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18" name="Prism 7" r:id="rId3" imgW="1955897" imgH="3235264" progId="Prism7.Document">
                  <p:embed/>
                </p:oleObj>
              </mc:Choice>
              <mc:Fallback>
                <p:oleObj name="Prism 7" r:id="rId3" imgW="1955897" imgH="3235264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306849" y="806081"/>
                        <a:ext cx="1108075" cy="18335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k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89129669"/>
              </p:ext>
            </p:extLst>
          </p:nvPr>
        </p:nvGraphicFramePr>
        <p:xfrm>
          <a:off x="2344126" y="815652"/>
          <a:ext cx="1108075" cy="1835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19" name="Prism 7" r:id="rId5" imgW="1955897" imgH="3235264" progId="Prism7.Document">
                  <p:embed/>
                </p:oleObj>
              </mc:Choice>
              <mc:Fallback>
                <p:oleObj name="Prism 7" r:id="rId5" imgW="1955897" imgH="3235264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344126" y="815652"/>
                        <a:ext cx="1108075" cy="1835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k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50621930"/>
              </p:ext>
            </p:extLst>
          </p:nvPr>
        </p:nvGraphicFramePr>
        <p:xfrm>
          <a:off x="3393435" y="812454"/>
          <a:ext cx="1108075" cy="18319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20" name="Prism 7" r:id="rId7" imgW="1955897" imgH="3235264" progId="Prism7.Document">
                  <p:embed/>
                </p:oleObj>
              </mc:Choice>
              <mc:Fallback>
                <p:oleObj name="Prism 7" r:id="rId7" imgW="1955897" imgH="3235264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393435" y="812454"/>
                        <a:ext cx="1108075" cy="18319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k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22444395"/>
              </p:ext>
            </p:extLst>
          </p:nvPr>
        </p:nvGraphicFramePr>
        <p:xfrm>
          <a:off x="4438650" y="808038"/>
          <a:ext cx="1120775" cy="18303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21" name="Prism 7" r:id="rId9" imgW="1974264" imgH="3229141" progId="Prism7.Document">
                  <p:embed/>
                </p:oleObj>
              </mc:Choice>
              <mc:Fallback>
                <p:oleObj name="Prism 7" r:id="rId9" imgW="1974264" imgH="3229141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438650" y="808038"/>
                        <a:ext cx="1120775" cy="18303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8" name="Gruppieren 17"/>
          <p:cNvGrpSpPr/>
          <p:nvPr/>
        </p:nvGrpSpPr>
        <p:grpSpPr>
          <a:xfrm>
            <a:off x="-5142" y="1068533"/>
            <a:ext cx="1343666" cy="1353151"/>
            <a:chOff x="-5142" y="1754333"/>
            <a:chExt cx="1343666" cy="1353151"/>
          </a:xfrm>
        </p:grpSpPr>
        <p:pic>
          <p:nvPicPr>
            <p:cNvPr id="8" name="Grafik 7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199991" y="1754333"/>
              <a:ext cx="1135463" cy="1135463"/>
            </a:xfrm>
            <a:prstGeom prst="rect">
              <a:avLst/>
            </a:prstGeom>
          </p:spPr>
        </p:pic>
        <p:grpSp>
          <p:nvGrpSpPr>
            <p:cNvPr id="10" name="Gruppieren 9"/>
            <p:cNvGrpSpPr/>
            <p:nvPr/>
          </p:nvGrpSpPr>
          <p:grpSpPr>
            <a:xfrm>
              <a:off x="-5142" y="1776859"/>
              <a:ext cx="1343666" cy="1330625"/>
              <a:chOff x="-3097149" y="1063723"/>
              <a:chExt cx="1343666" cy="1330625"/>
            </a:xfrm>
          </p:grpSpPr>
          <p:sp>
            <p:nvSpPr>
              <p:cNvPr id="13" name="Textfeld 12">
                <a:extLst>
                  <a:ext uri="{FF2B5EF4-FFF2-40B4-BE49-F238E27FC236}">
                    <a16:creationId xmlns:a16="http://schemas.microsoft.com/office/drawing/2014/main" xmlns="" id="{B570BCE5-C36B-4377-8E8B-ECF5DCC38980}"/>
                  </a:ext>
                </a:extLst>
              </p:cNvPr>
              <p:cNvSpPr txBox="1"/>
              <p:nvPr/>
            </p:nvSpPr>
            <p:spPr>
              <a:xfrm rot="16200000">
                <a:off x="-3241099" y="1854973"/>
                <a:ext cx="53412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CR7</a:t>
                </a:r>
              </a:p>
            </p:txBody>
          </p:sp>
          <p:cxnSp>
            <p:nvCxnSpPr>
              <p:cNvPr id="14" name="Gerade Verbindung mit Pfeil 13">
                <a:extLst>
                  <a:ext uri="{FF2B5EF4-FFF2-40B4-BE49-F238E27FC236}">
                    <a16:creationId xmlns:a16="http://schemas.microsoft.com/office/drawing/2014/main" xmlns="" id="{FF682C94-DE83-4546-9ED3-12BAB2D7284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-2969460" y="1063723"/>
                <a:ext cx="0" cy="635299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Gerade Verbindung mit Pfeil 14">
                <a:extLst>
                  <a:ext uri="{FF2B5EF4-FFF2-40B4-BE49-F238E27FC236}">
                    <a16:creationId xmlns:a16="http://schemas.microsoft.com/office/drawing/2014/main" xmlns="" id="{5F316F16-615C-43AA-8C8E-FE8B6BFFE1A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-2185483" y="2257923"/>
                <a:ext cx="43200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" name="Textfeld 15">
                <a:extLst>
                  <a:ext uri="{FF2B5EF4-FFF2-40B4-BE49-F238E27FC236}">
                    <a16:creationId xmlns:a16="http://schemas.microsoft.com/office/drawing/2014/main" xmlns="" id="{77954374-1F7E-492D-A69B-20020DEEB67A}"/>
                  </a:ext>
                </a:extLst>
              </p:cNvPr>
              <p:cNvSpPr txBox="1"/>
              <p:nvPr/>
            </p:nvSpPr>
            <p:spPr>
              <a:xfrm>
                <a:off x="-2880179" y="2148127"/>
                <a:ext cx="70403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D45RO</a:t>
                </a:r>
              </a:p>
            </p:txBody>
          </p:sp>
        </p:grpSp>
      </p:grpSp>
      <p:sp>
        <p:nvSpPr>
          <p:cNvPr id="19" name="Textfeld 18"/>
          <p:cNvSpPr txBox="1"/>
          <p:nvPr/>
        </p:nvSpPr>
        <p:spPr>
          <a:xfrm>
            <a:off x="41133" y="69920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A</a:t>
            </a:r>
          </a:p>
        </p:txBody>
      </p:sp>
      <p:sp>
        <p:nvSpPr>
          <p:cNvPr id="20" name="Textfeld 19"/>
          <p:cNvSpPr txBox="1"/>
          <p:nvPr/>
        </p:nvSpPr>
        <p:spPr>
          <a:xfrm>
            <a:off x="1419114" y="69920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B</a:t>
            </a:r>
          </a:p>
        </p:txBody>
      </p:sp>
      <p:sp>
        <p:nvSpPr>
          <p:cNvPr id="17" name="Textfeld 16"/>
          <p:cNvSpPr txBox="1"/>
          <p:nvPr/>
        </p:nvSpPr>
        <p:spPr>
          <a:xfrm>
            <a:off x="41133" y="5054051"/>
            <a:ext cx="6680257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6</a:t>
            </a:r>
            <a:r>
              <a:rPr lang="en-US" dirty="0"/>
              <a:t>: (A)Naïve and memory subsets were identified by using CD45 RO and CCR7. (B) Comparison of differentiation between the bulk population and virus-specific CD8+ T cells of aHCV, cHCV, rHCV, and SVR. (C) Correlation between CD127+ and TOX+ expression on virus-specific CD8+ T cells. Red dots represent the cHCV patients with on-target T cells, gray dots represent patients with unknown autologous viral sequence and purple dots patients with off-target T cells corresponding to the analyzed viral sequence.</a:t>
            </a:r>
            <a:endParaRPr lang="en-AU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12"/>
          <a:srcRect l="51454" t="14658" r="4190" b="30186"/>
          <a:stretch/>
        </p:blipFill>
        <p:spPr>
          <a:xfrm>
            <a:off x="5475927" y="1081178"/>
            <a:ext cx="1316739" cy="1316740"/>
          </a:xfrm>
          <a:prstGeom prst="rect">
            <a:avLst/>
          </a:prstGeom>
        </p:spPr>
      </p:pic>
      <p:graphicFrame>
        <p:nvGraphicFramePr>
          <p:cNvPr id="21" name="Objekt 20">
            <a:extLst>
              <a:ext uri="{FF2B5EF4-FFF2-40B4-BE49-F238E27FC236}">
                <a16:creationId xmlns:a16="http://schemas.microsoft.com/office/drawing/2014/main" xmlns="" id="{3A14E4E6-FF37-4387-879A-1AB6C8B0D2F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0974982"/>
              </p:ext>
            </p:extLst>
          </p:nvPr>
        </p:nvGraphicFramePr>
        <p:xfrm>
          <a:off x="-5142" y="2570903"/>
          <a:ext cx="3641725" cy="2409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22" name="Prism 7" r:id="rId13" imgW="4047925" imgH="2680266" progId="Prism7.Document">
                  <p:embed/>
                </p:oleObj>
              </mc:Choice>
              <mc:Fallback>
                <p:oleObj name="Prism 7" r:id="rId13" imgW="4047925" imgH="2680266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-5142" y="2570903"/>
                        <a:ext cx="3641725" cy="2409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2" name="Textfeld 21">
            <a:extLst>
              <a:ext uri="{FF2B5EF4-FFF2-40B4-BE49-F238E27FC236}">
                <a16:creationId xmlns:a16="http://schemas.microsoft.com/office/drawing/2014/main" xmlns="" id="{FFDF3D67-557A-4753-93B4-80C637A585EF}"/>
              </a:ext>
            </a:extLst>
          </p:cNvPr>
          <p:cNvSpPr txBox="1"/>
          <p:nvPr/>
        </p:nvSpPr>
        <p:spPr>
          <a:xfrm>
            <a:off x="770434" y="3577137"/>
            <a:ext cx="104547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>
                <a:latin typeface="+mj-lt"/>
              </a:rPr>
              <a:t>r</a:t>
            </a:r>
            <a:r>
              <a:rPr lang="en-AU" baseline="30000" dirty="0">
                <a:latin typeface="+mj-lt"/>
              </a:rPr>
              <a:t>2</a:t>
            </a:r>
            <a:r>
              <a:rPr lang="en-AU" dirty="0">
                <a:latin typeface="+mj-lt"/>
              </a:rPr>
              <a:t>:0,7085</a:t>
            </a:r>
          </a:p>
          <a:p>
            <a:r>
              <a:rPr lang="en-AU" dirty="0">
                <a:latin typeface="+mj-lt"/>
              </a:rPr>
              <a:t>p:0,0003</a:t>
            </a:r>
          </a:p>
        </p:txBody>
      </p:sp>
      <p:sp>
        <p:nvSpPr>
          <p:cNvPr id="23" name="Textfeld 22"/>
          <p:cNvSpPr txBox="1"/>
          <p:nvPr/>
        </p:nvSpPr>
        <p:spPr>
          <a:xfrm>
            <a:off x="41133" y="249758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85000023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k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03311184"/>
              </p:ext>
            </p:extLst>
          </p:nvPr>
        </p:nvGraphicFramePr>
        <p:xfrm>
          <a:off x="2251075" y="5925630"/>
          <a:ext cx="2192338" cy="2228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814" name="Prism 7" r:id="rId3" imgW="3723083" imgH="3784139" progId="Prism7.Document">
                  <p:embed/>
                </p:oleObj>
              </mc:Choice>
              <mc:Fallback>
                <p:oleObj name="Prism 7" r:id="rId3" imgW="3723083" imgH="3784139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251075" y="5925630"/>
                        <a:ext cx="2192338" cy="22288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k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09894488"/>
              </p:ext>
            </p:extLst>
          </p:nvPr>
        </p:nvGraphicFramePr>
        <p:xfrm>
          <a:off x="39368" y="6323287"/>
          <a:ext cx="2305050" cy="1866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815" name="Prism 7" r:id="rId5" imgW="3718401" imgH="3009807" progId="Prism7.Document">
                  <p:embed/>
                </p:oleObj>
              </mc:Choice>
              <mc:Fallback>
                <p:oleObj name="Prism 7" r:id="rId5" imgW="3718401" imgH="3009807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9368" y="6323287"/>
                        <a:ext cx="2305050" cy="1866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k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78510001"/>
              </p:ext>
            </p:extLst>
          </p:nvPr>
        </p:nvGraphicFramePr>
        <p:xfrm>
          <a:off x="30163" y="3971627"/>
          <a:ext cx="2309812" cy="2244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816" name="Prism 7" r:id="rId7" imgW="3723083" imgH="3618107" progId="Prism7.Document">
                  <p:embed/>
                </p:oleObj>
              </mc:Choice>
              <mc:Fallback>
                <p:oleObj name="Prism 7" r:id="rId7" imgW="3723083" imgH="3618107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0163" y="3971627"/>
                        <a:ext cx="2309812" cy="2244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k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23897260"/>
              </p:ext>
            </p:extLst>
          </p:nvPr>
        </p:nvGraphicFramePr>
        <p:xfrm>
          <a:off x="2230438" y="4014280"/>
          <a:ext cx="2305050" cy="21923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817" name="Prism 7" r:id="rId9" imgW="3718401" imgH="3535632" progId="Prism7.Document">
                  <p:embed/>
                </p:oleObj>
              </mc:Choice>
              <mc:Fallback>
                <p:oleObj name="Prism 7" r:id="rId9" imgW="3718401" imgH="3535632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230438" y="4014280"/>
                        <a:ext cx="2305050" cy="21923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k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70646097"/>
              </p:ext>
            </p:extLst>
          </p:nvPr>
        </p:nvGraphicFramePr>
        <p:xfrm>
          <a:off x="4467225" y="4212508"/>
          <a:ext cx="2308225" cy="1990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818" name="Prism 7" r:id="rId11" imgW="3723083" imgH="3209333" progId="Prism7.Document">
                  <p:embed/>
                </p:oleObj>
              </mc:Choice>
              <mc:Fallback>
                <p:oleObj name="Prism 7" r:id="rId11" imgW="3723083" imgH="3209333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467225" y="4212508"/>
                        <a:ext cx="2308225" cy="1990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k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57884836"/>
              </p:ext>
            </p:extLst>
          </p:nvPr>
        </p:nvGraphicFramePr>
        <p:xfrm>
          <a:off x="63500" y="2185480"/>
          <a:ext cx="2193925" cy="20843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819" name="Prism 7" r:id="rId13" imgW="3723083" imgH="3535632" progId="Prism7.Document">
                  <p:embed/>
                </p:oleObj>
              </mc:Choice>
              <mc:Fallback>
                <p:oleObj name="Prism 7" r:id="rId13" imgW="3723083" imgH="3535632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63500" y="2185480"/>
                        <a:ext cx="2193925" cy="20843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k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71890472"/>
              </p:ext>
            </p:extLst>
          </p:nvPr>
        </p:nvGraphicFramePr>
        <p:xfrm>
          <a:off x="2252663" y="2298193"/>
          <a:ext cx="2195512" cy="19669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820" name="Prism 7" r:id="rId15" imgW="3723083" imgH="3337547" progId="Prism7.Document">
                  <p:embed/>
                </p:oleObj>
              </mc:Choice>
              <mc:Fallback>
                <p:oleObj name="Prism 7" r:id="rId15" imgW="3723083" imgH="3337547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2252663" y="2298193"/>
                        <a:ext cx="2195512" cy="19669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k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61536583"/>
              </p:ext>
            </p:extLst>
          </p:nvPr>
        </p:nvGraphicFramePr>
        <p:xfrm>
          <a:off x="4498975" y="546342"/>
          <a:ext cx="2190750" cy="19351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821" name="Prism 7" r:id="rId17" imgW="3718401" imgH="3284245" progId="Prism7.Document">
                  <p:embed/>
                </p:oleObj>
              </mc:Choice>
              <mc:Fallback>
                <p:oleObj name="Prism 7" r:id="rId17" imgW="3718401" imgH="3284245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4498975" y="546342"/>
                        <a:ext cx="2190750" cy="19351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k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28700113"/>
              </p:ext>
            </p:extLst>
          </p:nvPr>
        </p:nvGraphicFramePr>
        <p:xfrm>
          <a:off x="2254250" y="351708"/>
          <a:ext cx="2192338" cy="21002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822" name="Prism 7" r:id="rId19" imgW="3718401" imgH="3563004" progId="Prism7.Document">
                  <p:embed/>
                </p:oleObj>
              </mc:Choice>
              <mc:Fallback>
                <p:oleObj name="Prism 7" r:id="rId19" imgW="3718401" imgH="3563004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2254250" y="351708"/>
                        <a:ext cx="2192338" cy="21002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k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64467966"/>
              </p:ext>
            </p:extLst>
          </p:nvPr>
        </p:nvGraphicFramePr>
        <p:xfrm>
          <a:off x="58738" y="94742"/>
          <a:ext cx="2195512" cy="23891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823" name="Prism 7" r:id="rId21" imgW="3723083" imgH="4052453" progId="Prism7.Document">
                  <p:embed/>
                </p:oleObj>
              </mc:Choice>
              <mc:Fallback>
                <p:oleObj name="Prism 7" r:id="rId21" imgW="3723083" imgH="4052453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58738" y="94742"/>
                        <a:ext cx="2195512" cy="23891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Textfeld 11"/>
          <p:cNvSpPr txBox="1"/>
          <p:nvPr/>
        </p:nvSpPr>
        <p:spPr>
          <a:xfrm>
            <a:off x="-4470" y="15495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A</a:t>
            </a:r>
          </a:p>
        </p:txBody>
      </p:sp>
      <p:sp>
        <p:nvSpPr>
          <p:cNvPr id="13" name="Textfeld 12"/>
          <p:cNvSpPr txBox="1"/>
          <p:nvPr/>
        </p:nvSpPr>
        <p:spPr>
          <a:xfrm>
            <a:off x="-17136" y="206976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B</a:t>
            </a:r>
          </a:p>
        </p:txBody>
      </p:sp>
      <p:sp>
        <p:nvSpPr>
          <p:cNvPr id="14" name="Textfeld 13"/>
          <p:cNvSpPr txBox="1"/>
          <p:nvPr/>
        </p:nvSpPr>
        <p:spPr>
          <a:xfrm>
            <a:off x="-4794" y="399436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C</a:t>
            </a:r>
          </a:p>
        </p:txBody>
      </p:sp>
      <p:sp>
        <p:nvSpPr>
          <p:cNvPr id="15" name="Textfeld 14"/>
          <p:cNvSpPr txBox="1"/>
          <p:nvPr/>
        </p:nvSpPr>
        <p:spPr>
          <a:xfrm>
            <a:off x="-17136" y="5914072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D</a:t>
            </a: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xmlns="" id="{A14F4F38-B4A1-4ECE-BC26-B1F5C9A3F1EE}"/>
              </a:ext>
            </a:extLst>
          </p:cNvPr>
          <p:cNvSpPr txBox="1"/>
          <p:nvPr/>
        </p:nvSpPr>
        <p:spPr>
          <a:xfrm>
            <a:off x="104173" y="8036589"/>
            <a:ext cx="6612038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b="1" dirty="0"/>
              <a:t>Supplementary </a:t>
            </a: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7: (A-D) Frequency of the indicated markers of HCV-specific and FLU-specific CD8+ T cells 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A-D) Frequency of the indicated markers in all different stages in HCV-specific CD8+ T Cells and FLU-specific CD8+ T cells. (Data are shown as mean ± SD, where *, **, ***, and **** indicate P values &lt;0.05, &lt;0.01, &lt;0.001, and &lt;0.0001. </a:t>
            </a:r>
            <a:endParaRPr lang="de-DE" sz="20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1424620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k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44634657"/>
              </p:ext>
            </p:extLst>
          </p:nvPr>
        </p:nvGraphicFramePr>
        <p:xfrm>
          <a:off x="-74613" y="488950"/>
          <a:ext cx="2265363" cy="15033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949" name="Prism 7" r:id="rId3" imgW="3997506" imgH="2652895" progId="Prism7.Document">
                  <p:embed/>
                </p:oleObj>
              </mc:Choice>
              <mc:Fallback>
                <p:oleObj name="Prism 7" r:id="rId3" imgW="3997506" imgH="2652895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-74613" y="488950"/>
                        <a:ext cx="2265363" cy="15033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k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64773379"/>
              </p:ext>
            </p:extLst>
          </p:nvPr>
        </p:nvGraphicFramePr>
        <p:xfrm>
          <a:off x="2338388" y="488950"/>
          <a:ext cx="2259012" cy="1501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950" name="Prism 7" r:id="rId5" imgW="3992825" imgH="2652895" progId="Prism7.Document">
                  <p:embed/>
                </p:oleObj>
              </mc:Choice>
              <mc:Fallback>
                <p:oleObj name="Prism 7" r:id="rId5" imgW="3992825" imgH="2652895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338388" y="488950"/>
                        <a:ext cx="2259012" cy="15017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k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72272258"/>
              </p:ext>
            </p:extLst>
          </p:nvPr>
        </p:nvGraphicFramePr>
        <p:xfrm>
          <a:off x="4748213" y="488950"/>
          <a:ext cx="2259012" cy="1501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951" name="Prism 7" r:id="rId7" imgW="3992825" imgH="2652895" progId="Prism7.Document">
                  <p:embed/>
                </p:oleObj>
              </mc:Choice>
              <mc:Fallback>
                <p:oleObj name="Prism 7" r:id="rId7" imgW="3992825" imgH="2652895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748213" y="488950"/>
                        <a:ext cx="2259012" cy="15017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k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08970296"/>
              </p:ext>
            </p:extLst>
          </p:nvPr>
        </p:nvGraphicFramePr>
        <p:xfrm>
          <a:off x="-49213" y="2109788"/>
          <a:ext cx="2260601" cy="1501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952" name="Prism 7" r:id="rId9" imgW="3992825" imgH="2652895" progId="Prism7.Document">
                  <p:embed/>
                </p:oleObj>
              </mc:Choice>
              <mc:Fallback>
                <p:oleObj name="Prism 7" r:id="rId9" imgW="3992825" imgH="2652895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-49213" y="2109788"/>
                        <a:ext cx="2260601" cy="15017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k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45162644"/>
              </p:ext>
            </p:extLst>
          </p:nvPr>
        </p:nvGraphicFramePr>
        <p:xfrm>
          <a:off x="2338388" y="2109788"/>
          <a:ext cx="2259012" cy="1501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953" name="Prism 7" r:id="rId11" imgW="3992825" imgH="2652895" progId="Prism7.Document">
                  <p:embed/>
                </p:oleObj>
              </mc:Choice>
              <mc:Fallback>
                <p:oleObj name="Prism 7" r:id="rId11" imgW="3992825" imgH="2652895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338388" y="2109788"/>
                        <a:ext cx="2259012" cy="15017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1" name="Grafik 20"/>
          <p:cNvPicPr>
            <a:picLocks noChangeAspect="1"/>
          </p:cNvPicPr>
          <p:nvPr/>
        </p:nvPicPr>
        <p:blipFill rotWithShape="1">
          <a:blip r:embed="rId13"/>
          <a:srcRect l="80345" b="44049"/>
          <a:stretch/>
        </p:blipFill>
        <p:spPr>
          <a:xfrm>
            <a:off x="5255865" y="2104210"/>
            <a:ext cx="910833" cy="1484475"/>
          </a:xfrm>
          <a:prstGeom prst="rect">
            <a:avLst/>
          </a:prstGeom>
        </p:spPr>
      </p:pic>
      <p:sp>
        <p:nvSpPr>
          <p:cNvPr id="12" name="Textfeld 11"/>
          <p:cNvSpPr txBox="1"/>
          <p:nvPr/>
        </p:nvSpPr>
        <p:spPr>
          <a:xfrm>
            <a:off x="1470965" y="2929659"/>
            <a:ext cx="6110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>
                <a:latin typeface="+mj-lt"/>
              </a:rPr>
              <a:t>r</a:t>
            </a:r>
            <a:r>
              <a:rPr lang="en-AU" sz="900" baseline="30000" dirty="0">
                <a:latin typeface="+mj-lt"/>
              </a:rPr>
              <a:t>2</a:t>
            </a:r>
            <a:r>
              <a:rPr lang="en-AU" sz="900" dirty="0">
                <a:latin typeface="+mj-lt"/>
              </a:rPr>
              <a:t>:0,7649</a:t>
            </a:r>
          </a:p>
          <a:p>
            <a:r>
              <a:rPr lang="en-AU" sz="900" dirty="0">
                <a:latin typeface="+mj-lt"/>
              </a:rPr>
              <a:t>p:0,0001</a:t>
            </a:r>
          </a:p>
        </p:txBody>
      </p:sp>
      <p:sp>
        <p:nvSpPr>
          <p:cNvPr id="13" name="Textfeld 12"/>
          <p:cNvSpPr txBox="1"/>
          <p:nvPr/>
        </p:nvSpPr>
        <p:spPr>
          <a:xfrm>
            <a:off x="2947068" y="2104210"/>
            <a:ext cx="121562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900" dirty="0">
                <a:latin typeface="+mj-lt"/>
              </a:rPr>
              <a:t>r</a:t>
            </a:r>
            <a:r>
              <a:rPr lang="en-AU" sz="900" baseline="30000" dirty="0">
                <a:latin typeface="+mj-lt"/>
              </a:rPr>
              <a:t>2</a:t>
            </a:r>
            <a:r>
              <a:rPr lang="en-AU" sz="900" dirty="0">
                <a:latin typeface="+mj-lt"/>
              </a:rPr>
              <a:t>:0,0018 p:0,7649</a:t>
            </a:r>
          </a:p>
        </p:txBody>
      </p:sp>
      <p:sp>
        <p:nvSpPr>
          <p:cNvPr id="14" name="Textfeld 13"/>
          <p:cNvSpPr txBox="1"/>
          <p:nvPr/>
        </p:nvSpPr>
        <p:spPr>
          <a:xfrm>
            <a:off x="1470965" y="488950"/>
            <a:ext cx="6110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>
                <a:latin typeface="+mj-lt"/>
              </a:rPr>
              <a:t>r</a:t>
            </a:r>
            <a:r>
              <a:rPr lang="en-AU" sz="900" baseline="30000" dirty="0">
                <a:latin typeface="+mj-lt"/>
              </a:rPr>
              <a:t>2</a:t>
            </a:r>
            <a:r>
              <a:rPr lang="en-AU" sz="900" dirty="0">
                <a:latin typeface="+mj-lt"/>
              </a:rPr>
              <a:t>:0,0323</a:t>
            </a:r>
          </a:p>
          <a:p>
            <a:r>
              <a:rPr lang="en-AU" sz="900" dirty="0">
                <a:latin typeface="+mj-lt"/>
              </a:rPr>
              <a:t>p:0,2064</a:t>
            </a:r>
          </a:p>
        </p:txBody>
      </p:sp>
      <p:sp>
        <p:nvSpPr>
          <p:cNvPr id="15" name="Textfeld 14"/>
          <p:cNvSpPr txBox="1"/>
          <p:nvPr/>
        </p:nvSpPr>
        <p:spPr>
          <a:xfrm>
            <a:off x="2888541" y="488950"/>
            <a:ext cx="6110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>
                <a:latin typeface="+mj-lt"/>
              </a:rPr>
              <a:t>r</a:t>
            </a:r>
            <a:r>
              <a:rPr lang="en-AU" sz="900" baseline="30000" dirty="0">
                <a:latin typeface="+mj-lt"/>
              </a:rPr>
              <a:t>2</a:t>
            </a:r>
            <a:r>
              <a:rPr lang="en-AU" sz="900" dirty="0">
                <a:latin typeface="+mj-lt"/>
              </a:rPr>
              <a:t>:0,3741</a:t>
            </a:r>
          </a:p>
          <a:p>
            <a:r>
              <a:rPr lang="en-AU" sz="900" dirty="0">
                <a:latin typeface="+mj-lt"/>
              </a:rPr>
              <a:t>p:0,0001</a:t>
            </a:r>
          </a:p>
        </p:txBody>
      </p:sp>
      <p:sp>
        <p:nvSpPr>
          <p:cNvPr id="16" name="Textfeld 15"/>
          <p:cNvSpPr txBox="1"/>
          <p:nvPr/>
        </p:nvSpPr>
        <p:spPr>
          <a:xfrm>
            <a:off x="5182389" y="488950"/>
            <a:ext cx="6110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900" dirty="0">
                <a:latin typeface="+mj-lt"/>
              </a:rPr>
              <a:t>r</a:t>
            </a:r>
            <a:r>
              <a:rPr lang="en-AU" sz="900" baseline="30000" dirty="0">
                <a:latin typeface="+mj-lt"/>
              </a:rPr>
              <a:t>2</a:t>
            </a:r>
            <a:r>
              <a:rPr lang="en-AU" sz="900" dirty="0">
                <a:latin typeface="+mj-lt"/>
              </a:rPr>
              <a:t>:0,0253</a:t>
            </a:r>
          </a:p>
          <a:p>
            <a:r>
              <a:rPr lang="en-AU" sz="900" dirty="0">
                <a:latin typeface="+mj-lt"/>
              </a:rPr>
              <a:t>p:0,2647</a:t>
            </a: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xmlns="" id="{141552B5-CB31-4086-8DF0-DADA36542F52}"/>
              </a:ext>
            </a:extLst>
          </p:cNvPr>
          <p:cNvSpPr txBox="1"/>
          <p:nvPr/>
        </p:nvSpPr>
        <p:spPr>
          <a:xfrm>
            <a:off x="208344" y="3763094"/>
            <a:ext cx="6319777" cy="2031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b="1" dirty="0">
                <a:latin typeface="Calibri (Textkörper)"/>
              </a:rPr>
              <a:t>Supplemental figure 8</a:t>
            </a:r>
            <a:r>
              <a:rPr lang="en-AU" dirty="0">
                <a:latin typeface="Calibri (Textkörper)"/>
              </a:rPr>
              <a:t>: </a:t>
            </a:r>
            <a:r>
              <a:rPr lang="en-US" sz="1800" dirty="0">
                <a:effectLst/>
                <a:latin typeface="Calibri (Textkörper)"/>
                <a:ea typeface="Calibri" panose="020F0502020204030204" pitchFamily="34" charset="0"/>
              </a:rPr>
              <a:t>Correlations between Frequencies of T-bet+, CD39+, CD73+, TIGIT+, KLRG1+ virus-specific CD8+ T cells and frequencies of TOX+ virus-specific CD8+ T cell. </a:t>
            </a:r>
            <a:r>
              <a:rPr lang="en-US" dirty="0"/>
              <a:t>Pearson correlation for parametric and Spearman correlation for non-parametric data were performed. P-values smaller than 0.05 were considered significant.</a:t>
            </a:r>
            <a:endParaRPr lang="de-DE" sz="1800" dirty="0">
              <a:effectLst/>
              <a:latin typeface="Calibri (Textkörper)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1752330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93</Words>
  <Application>Microsoft Office PowerPoint</Application>
  <PresentationFormat>A4-Papier (210x297 mm)</PresentationFormat>
  <Paragraphs>155</Paragraphs>
  <Slides>9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9</vt:i4>
      </vt:variant>
    </vt:vector>
  </HeadingPairs>
  <TitlesOfParts>
    <vt:vector size="16" baseType="lpstr">
      <vt:lpstr>Arial</vt:lpstr>
      <vt:lpstr>Calibri</vt:lpstr>
      <vt:lpstr>Calibri (Textkörper)</vt:lpstr>
      <vt:lpstr>Calibri Light</vt:lpstr>
      <vt:lpstr>Times New Roman</vt:lpstr>
      <vt:lpstr>Office Theme</vt:lpstr>
      <vt:lpstr>Prism 7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HP Inc.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icrosoft-Konto</dc:creator>
  <cp:lastModifiedBy>Microsoft-Konto</cp:lastModifiedBy>
  <cp:revision>274</cp:revision>
  <dcterms:created xsi:type="dcterms:W3CDTF">2021-01-24T16:27:56Z</dcterms:created>
  <dcterms:modified xsi:type="dcterms:W3CDTF">2022-04-10T17:19:30Z</dcterms:modified>
</cp:coreProperties>
</file>